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5" r:id="rId2"/>
    <p:sldId id="259" r:id="rId3"/>
  </p:sldIdLst>
  <p:sldSz cx="18000663" cy="158400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FF9933"/>
    <a:srgbClr val="CC99FF"/>
    <a:srgbClr val="FF0066"/>
    <a:srgbClr val="FF66FF"/>
    <a:srgbClr val="CCCC00"/>
    <a:srgbClr val="CC9900"/>
    <a:srgbClr val="009900"/>
    <a:srgbClr val="333399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5260" autoAdjust="0"/>
  </p:normalViewPr>
  <p:slideViewPr>
    <p:cSldViewPr snapToGrid="0">
      <p:cViewPr varScale="1">
        <p:scale>
          <a:sx n="29" d="100"/>
          <a:sy n="29" d="100"/>
        </p:scale>
        <p:origin x="173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592347"/>
            <a:ext cx="15300564" cy="5514693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8319707"/>
            <a:ext cx="13500497" cy="3824350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07337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93719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843338"/>
            <a:ext cx="3881393" cy="13423731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843338"/>
            <a:ext cx="11419171" cy="13423731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67109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11734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949023"/>
            <a:ext cx="15525572" cy="6589030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0600388"/>
            <a:ext cx="15525572" cy="3465015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515535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216687"/>
            <a:ext cx="7650282" cy="1005038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216687"/>
            <a:ext cx="7650282" cy="1005038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55324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843341"/>
            <a:ext cx="15525572" cy="306168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883019"/>
            <a:ext cx="7615123" cy="190300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786027"/>
            <a:ext cx="7615123" cy="851037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883019"/>
            <a:ext cx="7652626" cy="190300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786027"/>
            <a:ext cx="7652626" cy="851037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96927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12010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36597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056005"/>
            <a:ext cx="5805682" cy="3696018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280681"/>
            <a:ext cx="9112836" cy="11256720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752022"/>
            <a:ext cx="5805682" cy="8803710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51332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056005"/>
            <a:ext cx="5805682" cy="3696018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280681"/>
            <a:ext cx="9112836" cy="11256720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752022"/>
            <a:ext cx="5805682" cy="8803710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59071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843341"/>
            <a:ext cx="15525572" cy="30616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216687"/>
            <a:ext cx="15525572" cy="100503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4681406"/>
            <a:ext cx="4050149" cy="8433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150CE3-300D-491C-8007-5CD36EE97D7B}" type="datetimeFigureOut">
              <a:rPr lang="es-MX" smtClean="0"/>
              <a:t>12/01/20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4681406"/>
            <a:ext cx="6075224" cy="8433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4681406"/>
            <a:ext cx="4050149" cy="8433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687F4-5534-4548-B8AB-A1955E7F2BB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54093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71602E70-9F21-0173-A3D5-61D45B68A01A}"/>
              </a:ext>
            </a:extLst>
          </p:cNvPr>
          <p:cNvSpPr txBox="1"/>
          <p:nvPr/>
        </p:nvSpPr>
        <p:spPr>
          <a:xfrm>
            <a:off x="1905052" y="14082"/>
            <a:ext cx="894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roup A</a:t>
            </a:r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7EE6CC91-999F-57FF-EC51-9F145055AA6C}"/>
              </a:ext>
            </a:extLst>
          </p:cNvPr>
          <p:cNvSpPr txBox="1"/>
          <p:nvPr/>
        </p:nvSpPr>
        <p:spPr>
          <a:xfrm>
            <a:off x="12886" y="532140"/>
            <a:ext cx="936538" cy="2554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QEE16756.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3</a:t>
            </a:r>
          </a:p>
        </p:txBody>
      </p:sp>
      <p:sp>
        <p:nvSpPr>
          <p:cNvPr id="7" name="Rectangle 13">
            <a:extLst>
              <a:ext uri="{FF2B5EF4-FFF2-40B4-BE49-F238E27FC236}">
                <a16:creationId xmlns:a16="http://schemas.microsoft.com/office/drawing/2014/main" id="{FA3D4AFD-F737-0842-007B-4807DFA020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4863" y="326470"/>
            <a:ext cx="3362400" cy="1150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ILVSIIGNINLFQmDEDTLTTEQQDMLMDLEKAAMRARDLTNQLLTFSK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 -GGTPIKKPESIEQVIRDSANFILRGSK---SKCTFYFESNLPPVEIDVGQINQVLNNLL INASQAMPH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IDISVFREkidnkssiplipGCYIKLIIEDKGVGIPKSIQHKIFEPY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FTTKS----AGTGLGLSTSYSILKKHKGLITFSSKPGEGTIFYIYLPTTQ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9" name="Rectangle 14">
            <a:extLst>
              <a:ext uri="{FF2B5EF4-FFF2-40B4-BE49-F238E27FC236}">
                <a16:creationId xmlns:a16="http://schemas.microsoft.com/office/drawing/2014/main" id="{E75F4167-6376-136C-B317-2940AA3743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4944" y="1435362"/>
            <a:ext cx="3362400" cy="6892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VFVLDDDKNIHKFLIRAFSHLGLEMVSCYNGDHILEDFQAAEksgkkIDIVFM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TIP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GGKDAVKILRKKYPDLKIIVFSGYSNDPVIANFKDYGFDDFLEKPFSIEQLKAILSKW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I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1" name="Rectangle 15">
            <a:extLst>
              <a:ext uri="{FF2B5EF4-FFF2-40B4-BE49-F238E27FC236}">
                <a16:creationId xmlns:a16="http://schemas.microsoft.com/office/drawing/2014/main" id="{C71BC4FE-409E-6784-5480-1FFCBD37CB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4898" y="2140917"/>
            <a:ext cx="3157564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KIRFQRVFDRLPIPIAISDQNDQNLYVNPKFTEILGYTVNDIPNTESWMNLAYPD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3" name="Rectangle 16">
            <a:extLst>
              <a:ext uri="{FF2B5EF4-FFF2-40B4-BE49-F238E27FC236}">
                <a16:creationId xmlns:a16="http://schemas.microsoft.com/office/drawing/2014/main" id="{DB85F1C1-3CF4-F46A-9D83-3880552FCD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2200" y="2470178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QQRFRKIVEYFPYPIVVTTPRNDVVYVNPAFTKSLGFTIEDIPNAKTwyLKAYPNPEYR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NSII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5" name="Rectangle 17">
            <a:extLst>
              <a:ext uri="{FF2B5EF4-FFF2-40B4-BE49-F238E27FC236}">
                <a16:creationId xmlns:a16="http://schemas.microsoft.com/office/drawing/2014/main" id="{88D38198-A952-5FBD-7764-E5B08580B6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5848" y="2817873"/>
            <a:ext cx="3171212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EIKFQEIIENSRDMILLLNEKGIIQMINPAVTAIMGYSEDDIINHSP-LEFVLP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AC9219E2-B28E-4D5E-C107-A64E82C23A7F}"/>
              </a:ext>
            </a:extLst>
          </p:cNvPr>
          <p:cNvSpPr txBox="1"/>
          <p:nvPr/>
        </p:nvSpPr>
        <p:spPr>
          <a:xfrm>
            <a:off x="19200" y="3407370"/>
            <a:ext cx="1202637" cy="27084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WP_147663689.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3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03BBB00-DC56-1371-B16B-5069FDC0CB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9928" y="3292355"/>
            <a:ext cx="3362400" cy="1150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ILVSIIGNINLFQmDEDTLTTEQQDMLMDLEKAAMRARDLTNQLLTFSK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 -GGTPIKKPESIEQVIRDSANFILRGSK---SKCTFYFESNLPPVEIDVGQINQVLNNLL INASQAMPH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IDISVFREkidnkssiplipGCYIKLIIEDKGVGIPKSIQHKIFEPY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FTTKS----AGTGLGLSTSYSILKKHKGLITFSSKPGEGTIFYIYLPTTQ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1" name="Rectangle 19">
            <a:extLst>
              <a:ext uri="{FF2B5EF4-FFF2-40B4-BE49-F238E27FC236}">
                <a16:creationId xmlns:a16="http://schemas.microsoft.com/office/drawing/2014/main" id="{028D837E-F306-55F5-E57B-C320D8870E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5367" y="4418219"/>
            <a:ext cx="3362400" cy="6892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VFVLDDDKNIHKFLIRAFSHLGLEMVSCYNGDHILEDFQAAEksgkkIDIVFM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TIP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GGKDAVKILRKKYPDLKIIVFSGYSNDPVIANFKDYGFDDFLEKPFSIEQLKAILSKW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I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3" name="Rectangle 20">
            <a:extLst>
              <a:ext uri="{FF2B5EF4-FFF2-40B4-BE49-F238E27FC236}">
                <a16:creationId xmlns:a16="http://schemas.microsoft.com/office/drawing/2014/main" id="{C494D563-00C0-BE1E-FA5F-482397D8CA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7457" y="5147830"/>
            <a:ext cx="3163391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KIRFQRVFDRLPIPIAISDQNDQNLYVNPKFTEILGYTVNDIPNTESWMNLAYPD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5" name="Rectangle 21">
            <a:extLst>
              <a:ext uri="{FF2B5EF4-FFF2-40B4-BE49-F238E27FC236}">
                <a16:creationId xmlns:a16="http://schemas.microsoft.com/office/drawing/2014/main" id="{F475D8F0-7265-FEB5-D38E-27C0717343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8730" y="5483715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QQRFRKIVEYFPYPIVVTTPRNDVVYVNPAFTKSLGFTIEDIPNAKTwyLKAYPNPEYR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NSII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7" name="Rectangle 22">
            <a:extLst>
              <a:ext uri="{FF2B5EF4-FFF2-40B4-BE49-F238E27FC236}">
                <a16:creationId xmlns:a16="http://schemas.microsoft.com/office/drawing/2014/main" id="{579FAC5B-F43B-C846-4A17-076C5AEBA9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8683" y="5853138"/>
            <a:ext cx="3141042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EIKFQEIIENSRDMILLLNEKGIIQMINPAVTAIMGYSEDDIINHSP-LEFVLP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C2DA4122-B7C1-AE13-D502-B0A9DD78365D}"/>
              </a:ext>
            </a:extLst>
          </p:cNvPr>
          <p:cNvSpPr txBox="1"/>
          <p:nvPr/>
        </p:nvSpPr>
        <p:spPr>
          <a:xfrm>
            <a:off x="58988" y="6324592"/>
            <a:ext cx="1202637" cy="22467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WP_147664078.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</a:p>
        </p:txBody>
      </p:sp>
      <p:sp>
        <p:nvSpPr>
          <p:cNvPr id="31" name="Rectangle 10">
            <a:extLst>
              <a:ext uri="{FF2B5EF4-FFF2-40B4-BE49-F238E27FC236}">
                <a16:creationId xmlns:a16="http://schemas.microsoft.com/office/drawing/2014/main" id="{ED4CBF4B-D8D2-EB2D-BB46-F213AF9F80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9398" y="6243681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ILVGILGNVNLIQhSEENFSSEIGEMLEDISEATKKATALTRQLLTFSK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 -GGEPIKKAQDIEKIIEFSMKLVMPGS---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SICKFLPHdKVPPVNVDAGQIEQVINN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LLNADQAMEH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ITIALSQIqfkeldrkvmlkpGQYIKISISDQGIGIPPQVQKKIFS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PYFSTKP----NGNGLGLATVYSIIKKHNGKISFTSTVDVGTTFDIFLPVSQ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33" name="Rectangle 11">
            <a:extLst>
              <a:ext uri="{FF2B5EF4-FFF2-40B4-BE49-F238E27FC236}">
                <a16:creationId xmlns:a16="http://schemas.microsoft.com/office/drawing/2014/main" id="{09890634-3C11-3B5B-49A5-6FD54FC15C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1153" y="7491511"/>
            <a:ext cx="3362400" cy="6892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ILVLEDDSTVIKLLKKMFHILNQKADFVTDGYNILQLYEQALqnndpYDIVIM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TIP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MGGKDTIEALVKIDPDVTAIVSSGYSTDPVMANFSEYNFKGVLEKPFTINEVKKILLRW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35" name="Rectangle 12">
            <a:extLst>
              <a:ext uri="{FF2B5EF4-FFF2-40B4-BE49-F238E27FC236}">
                <a16:creationId xmlns:a16="http://schemas.microsoft.com/office/drawing/2014/main" id="{C08EC026-E13F-BD5F-82BB-63F7DC488F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9497" y="8205107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YKNLVEFSTDFIFSEDLHGEFIYINPTFNKTLGYSNEELLHKD-ISHLIHPEDLEG LIKAKLPLLEGK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411987E5-10E5-22A6-6983-D2FFC1207511}"/>
              </a:ext>
            </a:extLst>
          </p:cNvPr>
          <p:cNvSpPr txBox="1"/>
          <p:nvPr/>
        </p:nvSpPr>
        <p:spPr>
          <a:xfrm>
            <a:off x="15468" y="8684822"/>
            <a:ext cx="1225079" cy="22467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WP_147662496.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</p:txBody>
      </p:sp>
      <p:sp>
        <p:nvSpPr>
          <p:cNvPr id="39" name="Rectangle 6">
            <a:extLst>
              <a:ext uri="{FF2B5EF4-FFF2-40B4-BE49-F238E27FC236}">
                <a16:creationId xmlns:a16="http://schemas.microsoft.com/office/drawing/2014/main" id="{0D2A014F-B4E8-62F8-F14D-1B4E2F56AC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9113" y="8566275"/>
            <a:ext cx="3362400" cy="1150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A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ILTAVLGNTALLKMDLDQNSEKFTILNELESAIHRASKLTHQLLTFSK---- ---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SPIKKFMFIGDVIKESANFALhGTKNEIEFNFAPGLWPVHIDEGQISQVINNLV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INAVQATNI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SKIIIQANNYlmepennmmltpGNYVKISFQDFGNGILEENQEKIFDPY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FTTKE----TGSGLGLSVCYSILTRHSGKIKVTSKIGEGSTFTFYLPAHP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1" name="Rectangle 7">
            <a:extLst>
              <a:ext uri="{FF2B5EF4-FFF2-40B4-BE49-F238E27FC236}">
                <a16:creationId xmlns:a16="http://schemas.microsoft.com/office/drawing/2014/main" id="{DAA8B322-E57E-9417-EBD2-9618A44950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3067" y="9719227"/>
            <a:ext cx="3362400" cy="6892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ILILEDEKPIRVLLEKFLRKKNFYVESAADGEEILIKYQDALdkgqeFDILIL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TIk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GMGGEETFQKLLEINPNVKAIVASGYSTKKILSDYKQYGFAGMLSKPFKMSDLLKEIERL 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3" name="Rectangle 8">
            <a:extLst>
              <a:ext uri="{FF2B5EF4-FFF2-40B4-BE49-F238E27FC236}">
                <a16:creationId xmlns:a16="http://schemas.microsoft.com/office/drawing/2014/main" id="{21302CDB-6E18-EB95-793A-60DE5E405B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9659" y="10344851"/>
            <a:ext cx="3359762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TLFFQKILNNLPEPAFAVDSNCKIIEWNKAMEEFSGIKAELIIGKT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5" name="Rectangle 9">
            <a:extLst>
              <a:ext uri="{FF2B5EF4-FFF2-40B4-BE49-F238E27FC236}">
                <a16:creationId xmlns:a16="http://schemas.microsoft.com/office/drawing/2014/main" id="{E06638DD-27F9-0886-4496-FE7623DC40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7020" y="10637354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KEMLAVTLAGIVDGVITLDADANIILINKVAENILEMDYDEVFGKKIfnITTLYKDKSR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PYELYeVKNMLGKR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5349F293-3405-148E-EAB4-CCE89E986D82}"/>
              </a:ext>
            </a:extLst>
          </p:cNvPr>
          <p:cNvSpPr txBox="1"/>
          <p:nvPr/>
        </p:nvSpPr>
        <p:spPr>
          <a:xfrm>
            <a:off x="82300" y="11125373"/>
            <a:ext cx="1202637" cy="24006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WP_147664519.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</a:p>
        </p:txBody>
      </p:sp>
      <p:sp>
        <p:nvSpPr>
          <p:cNvPr id="49" name="Rectangle 1">
            <a:extLst>
              <a:ext uri="{FF2B5EF4-FFF2-40B4-BE49-F238E27FC236}">
                <a16:creationId xmlns:a16="http://schemas.microsoft.com/office/drawing/2014/main" id="{92439817-FBB6-BE2B-3D8A-5FC0188CE4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1425" y="11042068"/>
            <a:ext cx="3362400" cy="1458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LLQAVFGHLDLILlEFENNNDKDKEILDSLFKiksAAEHGAEITHQLLTLSK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IHN----VEFSSININDEILEIYSILKHSIP-KMVEINLELSEDMDPIYGNSTSIQQVIM NLVLNARDALQD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KISIKTDEVilddlfcemfanltpGKYISITITDTGIGMSQEVL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HLFEPYYSTKP--HGKGTGLGLSIVYNIIQQHNGSIQCYSEVDRGTRFKIFLPVN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1" name="Rectangle 2">
            <a:extLst>
              <a:ext uri="{FF2B5EF4-FFF2-40B4-BE49-F238E27FC236}">
                <a16:creationId xmlns:a16="http://schemas.microsoft.com/office/drawing/2014/main" id="{4B8F1669-C2BF-AEE3-7952-23A4F4B078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1425" y="12469162"/>
            <a:ext cx="3362400" cy="6892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ILVIDDNEEILEYTIKILKKFGYNVLIANSCKNIHEILKRNKrIDLFIV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IMPHTGG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CIRNIReKLDYNTKYILSSGMGSEKLNEECEINKIDTFLPKPYTMGDLLLIIQSV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3" name="Rectangle 3">
            <a:extLst>
              <a:ext uri="{FF2B5EF4-FFF2-40B4-BE49-F238E27FC236}">
                <a16:creationId xmlns:a16="http://schemas.microsoft.com/office/drawing/2014/main" id="{058523DE-F953-A83B-EE56-F9E8A6A50D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2168" y="13282166"/>
            <a:ext cx="3493264" cy="2276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QGRFQELVETMDEGIYEYDLSGNCTYSNEAHYKVLGYHVN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97E4BDFE-7EF4-25B5-7BE2-A7667454FF50}"/>
              </a:ext>
            </a:extLst>
          </p:cNvPr>
          <p:cNvSpPr txBox="1"/>
          <p:nvPr/>
        </p:nvSpPr>
        <p:spPr>
          <a:xfrm>
            <a:off x="350976" y="13601190"/>
            <a:ext cx="912429" cy="17851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QEE16389.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4">
            <a:extLst>
              <a:ext uri="{FF2B5EF4-FFF2-40B4-BE49-F238E27FC236}">
                <a16:creationId xmlns:a16="http://schemas.microsoft.com/office/drawing/2014/main" id="{6A3199D8-2AE3-E737-827E-30D02775E0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3509" y="13513291"/>
            <a:ext cx="3362400" cy="1458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VLTVILGLSNLTIdslRDENEEINRNELIKNLEDvlrAGDRAAKLTKDVLTF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SRKQ----VFQSQIVNLNKLLKNNKDMLARVL-GENISFNLKLDQENKSIEIDPNQMSLV ILNMAINSRDAMPN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DFTIETSRTylskglkgfnlkpGNYIKISLRDTGIGMDETHKQ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HLFEPFFTTKE--KGKGTGLGLSIAFGIIKQYHGEIKVESKLGTGTVFHIYLPEID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9" name="Rectangle 5">
            <a:extLst>
              <a:ext uri="{FF2B5EF4-FFF2-40B4-BE49-F238E27FC236}">
                <a16:creationId xmlns:a16="http://schemas.microsoft.com/office/drawing/2014/main" id="{1932FAE0-5132-9F6D-81E4-C668EA0698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7003" y="15025056"/>
            <a:ext cx="3362400" cy="6892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ILLVEDEEMVRKFAFRVLNSHGYNCLEAKSPKEAIKISQEYHekIDLLL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IMPDFS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LELKKKIEKRHPDMIILFISGYDANIISNNGELEVGINLLKKPFSSIELLERIHLL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452442E0-3DD9-B10B-4469-087D394CDB25}"/>
              </a:ext>
            </a:extLst>
          </p:cNvPr>
          <p:cNvSpPr txBox="1"/>
          <p:nvPr/>
        </p:nvSpPr>
        <p:spPr>
          <a:xfrm>
            <a:off x="4451897" y="140148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6010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23">
            <a:extLst>
              <a:ext uri="{FF2B5EF4-FFF2-40B4-BE49-F238E27FC236}">
                <a16:creationId xmlns:a16="http://schemas.microsoft.com/office/drawing/2014/main" id="{6D451408-26C6-250B-D669-AD481FBA11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97742" y="13872"/>
            <a:ext cx="3362400" cy="6892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ILLIEDDLETVNLLTSYFESIGISCKGVTSGFKALKELKGYIPKLILL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ILPDINGYE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KRIKvdKKFEDVPIFFLTAIPSVEVERKKREFGVTGVILKPFNLSDFDVIHKYLK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22C2C0E4-DD48-00BC-4AA0-AAF5A068FAF5}"/>
              </a:ext>
            </a:extLst>
          </p:cNvPr>
          <p:cNvSpPr txBox="1"/>
          <p:nvPr/>
        </p:nvSpPr>
        <p:spPr>
          <a:xfrm>
            <a:off x="6350447" y="681975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roup B</a:t>
            </a:r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3">
            <a:extLst>
              <a:ext uri="{FF2B5EF4-FFF2-40B4-BE49-F238E27FC236}">
                <a16:creationId xmlns:a16="http://schemas.microsoft.com/office/drawing/2014/main" id="{C9F86981-0A8D-21CD-F322-C66B6CE8A2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28729" y="2355423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SQWYITTLKSIGDAVIATDKEGKILFLNSVAESLTGWSGNDAVGLPLekVFNIINEDT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KVENPVSTVIKT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536E69D4-1BEC-DE7F-E58D-724C8A11275F}"/>
              </a:ext>
            </a:extLst>
          </p:cNvPr>
          <p:cNvSpPr txBox="1"/>
          <p:nvPr/>
        </p:nvSpPr>
        <p:spPr>
          <a:xfrm>
            <a:off x="4327115" y="1024448"/>
            <a:ext cx="922047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6579.1 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1">
            <a:extLst>
              <a:ext uri="{FF2B5EF4-FFF2-40B4-BE49-F238E27FC236}">
                <a16:creationId xmlns:a16="http://schemas.microsoft.com/office/drawing/2014/main" id="{BCEA14D3-80BA-04B9-FE89-8BCC58C3D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19703" y="931999"/>
            <a:ext cx="3362400" cy="14740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F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INNILQNVLSSVDTILlanEKPEGKEISDDMLKIITEQVNRGAKLVTNVRRLSE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DD--TKIILRDIESFDLLEKAVKYIEESYKDKNLKITIDSE-NRSYNVYANELLLDVFEN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LINAVKYNDNTEIEIIIKITKEkkdnRNFAKFEFMDNGIGIQDERKQIVFERTNR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 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FDGMGLGLSLVNHIINKFEGFIWVEDRVKNdytkGSNFAILIPEVT</a:t>
            </a:r>
            <a:r>
              <a:rPr lang="es-MX" altLang="es-MX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s-MX" altLang="es-MX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3" name="Rectangle 1">
            <a:extLst>
              <a:ext uri="{FF2B5EF4-FFF2-40B4-BE49-F238E27FC236}">
                <a16:creationId xmlns:a16="http://schemas.microsoft.com/office/drawing/2014/main" id="{9EF80060-FBF7-B147-BA64-7E47642169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4247" y="2860721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F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INNILQNVLSSVDTILlanEKPEGKDISDDMLKTITEQVNRGAKLVSNVRSLSE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DDA--KIVLGEIESFNFIEKAVKYVEECYKEKNLKITIDAE-NRSYNVIANELILDVFEN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LINAVKYNDNTEIEIIIKISKEkkdkRNFTKFEFMDNGIGIQEERKQNVFERTNR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SFNGMGLGLSLVNHIISKYEGHIWVEDRVKNdytkGSNFVILIPEVT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62447A2E-946C-79CE-E9F0-581131EFBACF}"/>
              </a:ext>
            </a:extLst>
          </p:cNvPr>
          <p:cNvSpPr txBox="1"/>
          <p:nvPr/>
        </p:nvSpPr>
        <p:spPr>
          <a:xfrm>
            <a:off x="4316842" y="3007416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5609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2">
            <a:extLst>
              <a:ext uri="{FF2B5EF4-FFF2-40B4-BE49-F238E27FC236}">
                <a16:creationId xmlns:a16="http://schemas.microsoft.com/office/drawing/2014/main" id="{668AF68B-E1B5-D980-BE7A-EAC29B63E4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1941" y="4252891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SQWYFTTLKSIGDAVIATDKEGKILFLNSVAESLTGWLSNEAVGLPLekVFNIINEET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KVENPVSTVIKT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E552CC68-154F-7F41-31BB-AE6ABDA09B6F}"/>
              </a:ext>
            </a:extLst>
          </p:cNvPr>
          <p:cNvSpPr txBox="1"/>
          <p:nvPr/>
        </p:nvSpPr>
        <p:spPr>
          <a:xfrm>
            <a:off x="4309585" y="4348457"/>
            <a:ext cx="9285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2">
            <a:extLst>
              <a:ext uri="{FF2B5EF4-FFF2-40B4-BE49-F238E27FC236}">
                <a16:creationId xmlns:a16="http://schemas.microsoft.com/office/drawing/2014/main" id="{4E7CBB65-852D-884F-6FAD-3A56FB8C21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9141" y="4659589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FF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INNILQHILSATDLYEnylKLPNDKQKIENIPNIIRNQVLRGAKLISNIRKISD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IE--KAPIKTVDLCEHLNESVNLLTNSYKDKDIKIVIDTP-LKDLRIEASDLFHDVCDN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LFNAIKHNNKPTPEILIKISKLqkdeRNYIRTEFLDNGRGIEDNRKKQIFQRGFNDDRS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T-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GMGLGLSLVKKIIDSYDGDIWVEDKVIGdytkGSKFIVLIPEGI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id="{65067C40-53EA-4C9D-52ED-867F0F443F42}"/>
              </a:ext>
            </a:extLst>
          </p:cNvPr>
          <p:cNvSpPr txBox="1"/>
          <p:nvPr/>
        </p:nvSpPr>
        <p:spPr>
          <a:xfrm>
            <a:off x="4337097" y="4787840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6537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1">
            <a:extLst>
              <a:ext uri="{FF2B5EF4-FFF2-40B4-BE49-F238E27FC236}">
                <a16:creationId xmlns:a16="http://schemas.microsoft.com/office/drawing/2014/main" id="{873DCB02-A0F7-0E61-40A5-0C5120AFEC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3099" y="5902119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VN</a:t>
            </a:r>
            <a:r>
              <a:rPr lang="es-MX" altLang="es-MX" sz="1000" dirty="0">
                <a:solidFill>
                  <a:srgbClr val="000000"/>
                </a:solidFill>
                <a:highlight>
                  <a:srgbClr val="FF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FQNILSSIEISKEYLDDYLEKKEILSDMNNLINDQIVKGKKLVLNVQNLSLVED- -TGLVLSPIEVLDNLEKIIDVIKEDFQHRNIEIQIESE-QSMYIVNADKLLKNIFENIFT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SIKHNQNSNIEIFIRVSRKkkngVNFIKITFIDNGLGIPDLMKLTIFSRDFRK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SGNY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IGLGLLLVKRILEKYNGEIIVKDRVKGdytkGSKFLILIPEFN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87" name="CuadroTexto 86">
            <a:extLst>
              <a:ext uri="{FF2B5EF4-FFF2-40B4-BE49-F238E27FC236}">
                <a16:creationId xmlns:a16="http://schemas.microsoft.com/office/drawing/2014/main" id="{BC6D8789-6039-3406-3FE3-9A5BB2DA809E}"/>
              </a:ext>
            </a:extLst>
          </p:cNvPr>
          <p:cNvSpPr txBox="1"/>
          <p:nvPr/>
        </p:nvSpPr>
        <p:spPr>
          <a:xfrm>
            <a:off x="4326006" y="6067202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0347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18">
            <a:extLst>
              <a:ext uri="{FF2B5EF4-FFF2-40B4-BE49-F238E27FC236}">
                <a16:creationId xmlns:a16="http://schemas.microsoft.com/office/drawing/2014/main" id="{46D0135D-457E-B2DF-EDCE-0EF0639FFA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8866" y="7233961"/>
            <a:ext cx="3362400" cy="1150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LQEPLRMVISFTQLLAkrYNDKLDEDAKDYINFAVDGARRMQTLINDLLSYSRIT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TR--GDPFKIVNLKNVLEDIILNLQIKIKETSAKITYGEM---PSLFADKTQLMQLFQNL ISNALRFRSKELPLIHISAQHSYKEWIFSVKDNGIGIEQRFFKKIFVIFQRLHTRDEYPG SGIGLAICKRIVEKLNGRIWVESEVGKGSTFKFAIPLKK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91" name="CuadroTexto 90">
            <a:extLst>
              <a:ext uri="{FF2B5EF4-FFF2-40B4-BE49-F238E27FC236}">
                <a16:creationId xmlns:a16="http://schemas.microsoft.com/office/drawing/2014/main" id="{715E0F38-A460-DC57-5D00-0FCD1BC3EFBA}"/>
              </a:ext>
            </a:extLst>
          </p:cNvPr>
          <p:cNvSpPr txBox="1"/>
          <p:nvPr/>
        </p:nvSpPr>
        <p:spPr>
          <a:xfrm>
            <a:off x="4326006" y="7306597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0193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CuadroTexto 92">
            <a:extLst>
              <a:ext uri="{FF2B5EF4-FFF2-40B4-BE49-F238E27FC236}">
                <a16:creationId xmlns:a16="http://schemas.microsoft.com/office/drawing/2014/main" id="{C075845F-A57D-0E5C-0463-199C59EE0A34}"/>
              </a:ext>
            </a:extLst>
          </p:cNvPr>
          <p:cNvSpPr txBox="1"/>
          <p:nvPr/>
        </p:nvSpPr>
        <p:spPr>
          <a:xfrm>
            <a:off x="6383083" y="8420153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roup C</a:t>
            </a:r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CuadroTexto 94">
            <a:extLst>
              <a:ext uri="{FF2B5EF4-FFF2-40B4-BE49-F238E27FC236}">
                <a16:creationId xmlns:a16="http://schemas.microsoft.com/office/drawing/2014/main" id="{A694EF19-442B-9532-8E7E-F38B1F2787EB}"/>
              </a:ext>
            </a:extLst>
          </p:cNvPr>
          <p:cNvSpPr txBox="1"/>
          <p:nvPr/>
        </p:nvSpPr>
        <p:spPr>
          <a:xfrm>
            <a:off x="4328154" y="8793724"/>
            <a:ext cx="12025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WP_147663673.1</a:t>
            </a:r>
          </a:p>
        </p:txBody>
      </p:sp>
      <p:sp>
        <p:nvSpPr>
          <p:cNvPr id="97" name="Rectangle 3">
            <a:extLst>
              <a:ext uri="{FF2B5EF4-FFF2-40B4-BE49-F238E27FC236}">
                <a16:creationId xmlns:a16="http://schemas.microsoft.com/office/drawing/2014/main" id="{87C072DF-9DBA-9059-F488-DB86864692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76323" y="8692070"/>
            <a:ext cx="3362400" cy="1150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M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RTPLNSIIGFSDVLLekYYGELNDQQEIYLNNVKSSAGHLLNLINDILDISKI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AGKVELNIQKISIHKVLKQTEITLRPEFEKKNLKFEMVGLNSEQVVPVDLIRFKEILYNL LSNAIKYTKK-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VKLEVIEEEDLWKFNVIDTGIGIKEEHFDLIFNEFERIQSeyVSSV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GTGLGLSLTKRLVELHGGNISFTSKWEEGSIFTFTLPKK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99" name="Rectangle 4">
            <a:extLst>
              <a:ext uri="{FF2B5EF4-FFF2-40B4-BE49-F238E27FC236}">
                <a16:creationId xmlns:a16="http://schemas.microsoft.com/office/drawing/2014/main" id="{B026A85E-F6E4-6F74-9C13-A2411FBF45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73161" y="9857046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AKLQSVFKTSNEGFWESNNEDITIDVNPKMCEILGRTREEIIGRDS-HELLTPDGKDK ISFQHEEYRKK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01" name="Rectangle 5">
            <a:extLst>
              <a:ext uri="{FF2B5EF4-FFF2-40B4-BE49-F238E27FC236}">
                <a16:creationId xmlns:a16="http://schemas.microsoft.com/office/drawing/2014/main" id="{52CCDD19-FEA8-1E11-B7F0-B9B298273E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6811" y="10246383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NYILANIVENSNDAIISLNIDGSIISWNKGAENVFGYKEKEIKGKN--YSLLGPENLTI DQTLIFNEVKNS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03" name="CuadroTexto 102">
            <a:extLst>
              <a:ext uri="{FF2B5EF4-FFF2-40B4-BE49-F238E27FC236}">
                <a16:creationId xmlns:a16="http://schemas.microsoft.com/office/drawing/2014/main" id="{B9E25F70-E056-F23C-F83B-7AFD1279D34E}"/>
              </a:ext>
            </a:extLst>
          </p:cNvPr>
          <p:cNvSpPr txBox="1"/>
          <p:nvPr/>
        </p:nvSpPr>
        <p:spPr>
          <a:xfrm>
            <a:off x="4256204" y="9747813"/>
            <a:ext cx="120257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</p:txBody>
      </p:sp>
      <p:sp>
        <p:nvSpPr>
          <p:cNvPr id="105" name="CuadroTexto 104">
            <a:extLst>
              <a:ext uri="{FF2B5EF4-FFF2-40B4-BE49-F238E27FC236}">
                <a16:creationId xmlns:a16="http://schemas.microsoft.com/office/drawing/2014/main" id="{271DD890-0B98-DC7E-14B7-381719A200F5}"/>
              </a:ext>
            </a:extLst>
          </p:cNvPr>
          <p:cNvSpPr txBox="1"/>
          <p:nvPr/>
        </p:nvSpPr>
        <p:spPr>
          <a:xfrm>
            <a:off x="4574839" y="10732037"/>
            <a:ext cx="912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QEE16740.1</a:t>
            </a:r>
          </a:p>
        </p:txBody>
      </p:sp>
      <p:sp>
        <p:nvSpPr>
          <p:cNvPr id="107" name="Rectangle 6">
            <a:extLst>
              <a:ext uri="{FF2B5EF4-FFF2-40B4-BE49-F238E27FC236}">
                <a16:creationId xmlns:a16="http://schemas.microsoft.com/office/drawing/2014/main" id="{ECACC38D-72BE-C003-2917-3F9DB8F282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2451" y="10615438"/>
            <a:ext cx="3362400" cy="1150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M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RTPLNSIIGFSDVLLekYYGELNDQQEIYLNNVKSSAGHLLNLINDILDISKI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AGKVELNIQKISIHKVLKQTEITLRPEFEKKNLKFEMVGLNSEQVVPVDLIRFKEILYNL LSNAIKYTKK-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VKLEVIEEEDLWKFNVIDTGIGIKEEHFDLIFNEFERIQSeyVSSV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GTGLGLSLTKRLVELHGGNISFTSKWEEGSIFTFTLPKK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09" name="Rectangle 7">
            <a:extLst>
              <a:ext uri="{FF2B5EF4-FFF2-40B4-BE49-F238E27FC236}">
                <a16:creationId xmlns:a16="http://schemas.microsoft.com/office/drawing/2014/main" id="{B9516E74-C524-36B2-A01A-D56D10FE56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4844" y="11798475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AKLQSVFKTSNEGFWESNNEDITIDVNPKMCEILGRTREEIIGRDS-HELLTPDGKDK ISFQHEEYRKK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11" name="CuadroTexto 110">
            <a:extLst>
              <a:ext uri="{FF2B5EF4-FFF2-40B4-BE49-F238E27FC236}">
                <a16:creationId xmlns:a16="http://schemas.microsoft.com/office/drawing/2014/main" id="{2BF30109-AA4A-3180-A179-20E3B4E494DA}"/>
              </a:ext>
            </a:extLst>
          </p:cNvPr>
          <p:cNvSpPr txBox="1"/>
          <p:nvPr/>
        </p:nvSpPr>
        <p:spPr>
          <a:xfrm>
            <a:off x="4944090" y="11826135"/>
            <a:ext cx="51815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</p:txBody>
      </p:sp>
      <p:sp>
        <p:nvSpPr>
          <p:cNvPr id="113" name="Rectangle 8">
            <a:extLst>
              <a:ext uri="{FF2B5EF4-FFF2-40B4-BE49-F238E27FC236}">
                <a16:creationId xmlns:a16="http://schemas.microsoft.com/office/drawing/2014/main" id="{58F5B0EF-65E5-250B-8A9B-46DBBBD7A8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47197" y="12133319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NYILANIVENSNDAIISLNIDGSIISWNKGAENVFGYKEKEIKGKN--YSLLGPENLTI DQTLIFNEVKNS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15" name="Rectangle 9">
            <a:extLst>
              <a:ext uri="{FF2B5EF4-FFF2-40B4-BE49-F238E27FC236}">
                <a16:creationId xmlns:a16="http://schemas.microsoft.com/office/drawing/2014/main" id="{CFD79613-3060-E221-88DA-ED16AA3A8E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7545" y="12532980"/>
            <a:ext cx="3362400" cy="1150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M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RTPLNSIIGFSDILKekFYGDLNEKQENYIENVRSSAQHLLELINDILDISKI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AGKITLRFVDVNLKELLNQIGTTIRPEYEKKNLTFEIIGLEEGKMIKCDPKRFKEIIFNL LSNAIKYTIS-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ITLEIFETRNHWEFSVIDTGIGIEEKDFKFIFQDFKRLKNehTATV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GTGLGLSLTKRLIELHNGNISFKSKWKEGSTFTITLPKFS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17" name="CuadroTexto 116">
            <a:extLst>
              <a:ext uri="{FF2B5EF4-FFF2-40B4-BE49-F238E27FC236}">
                <a16:creationId xmlns:a16="http://schemas.microsoft.com/office/drawing/2014/main" id="{F8185453-4599-EBE9-E008-6E9B7118D801}"/>
              </a:ext>
            </a:extLst>
          </p:cNvPr>
          <p:cNvSpPr txBox="1"/>
          <p:nvPr/>
        </p:nvSpPr>
        <p:spPr>
          <a:xfrm>
            <a:off x="4521635" y="12612797"/>
            <a:ext cx="912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QEE16628.1</a:t>
            </a:r>
          </a:p>
        </p:txBody>
      </p:sp>
      <p:sp>
        <p:nvSpPr>
          <p:cNvPr id="119" name="Rectangle 10">
            <a:extLst>
              <a:ext uri="{FF2B5EF4-FFF2-40B4-BE49-F238E27FC236}">
                <a16:creationId xmlns:a16="http://schemas.microsoft.com/office/drawing/2014/main" id="{1AB3F209-A025-E25D-A5BD-5B7553C5AB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5714" y="13707711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KKYSNLVDNLTDIVGVIDKKGKIIYGNSQMYTSLGYKPEELKGQNFFALYLDPK---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21" name="Rectangle 11">
            <a:extLst>
              <a:ext uri="{FF2B5EF4-FFF2-40B4-BE49-F238E27FC236}">
                <a16:creationId xmlns:a16="http://schemas.microsoft.com/office/drawing/2014/main" id="{87F9A073-6D1D-3FF0-072D-A77864E96D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5717" y="14062518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LKKYTNLVNNLTDIIGAVDPKGKINYCNPQVYTLLGYKPEELLGQKFFKLLANPK---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23" name="Rectangle 12">
            <a:extLst>
              <a:ext uri="{FF2B5EF4-FFF2-40B4-BE49-F238E27FC236}">
                <a16:creationId xmlns:a16="http://schemas.microsoft.com/office/drawing/2014/main" id="{85FD2471-2631-C3B1-9408-974AB2D616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5718" y="14383151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KENLLKMVENSDDAFINMDLDGTMIYWNKGAEQTFGYTAKEVLYRKN-LDLVPPDRYEE RKFIFDRIKKG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25" name="CuadroTexto 124">
            <a:extLst>
              <a:ext uri="{FF2B5EF4-FFF2-40B4-BE49-F238E27FC236}">
                <a16:creationId xmlns:a16="http://schemas.microsoft.com/office/drawing/2014/main" id="{4539BEB0-6D57-5BDD-17DF-29D141949D87}"/>
              </a:ext>
            </a:extLst>
          </p:cNvPr>
          <p:cNvSpPr txBox="1"/>
          <p:nvPr/>
        </p:nvSpPr>
        <p:spPr>
          <a:xfrm>
            <a:off x="4507467" y="13469762"/>
            <a:ext cx="936538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3</a:t>
            </a:r>
          </a:p>
        </p:txBody>
      </p:sp>
      <p:sp>
        <p:nvSpPr>
          <p:cNvPr id="127" name="Rectangle 13">
            <a:extLst>
              <a:ext uri="{FF2B5EF4-FFF2-40B4-BE49-F238E27FC236}">
                <a16:creationId xmlns:a16="http://schemas.microsoft.com/office/drawing/2014/main" id="{DC529611-5B15-6641-FE15-8DE6A074D6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98117" y="21564"/>
            <a:ext cx="3362400" cy="1150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M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RTPLNSIIGFTDILIekFYGDVNEKQDHYLNNVRTSAEHLLNLINDILDISKI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AGKVELKYRDFDLLNLVSQIEIEVKPLYKKKGLNFELVGFEKGTIINADPIRFKEILLNL LSNAIKYTEK-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IKLDFMEDEKNWKFKIIDTGIGIAPEDFGIIFQEFKRVESdyVES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GTGLGLMLTKKLIELHGGHITFTSVLGEGSSFSFTLPKK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29" name="CuadroTexto 128">
            <a:extLst>
              <a:ext uri="{FF2B5EF4-FFF2-40B4-BE49-F238E27FC236}">
                <a16:creationId xmlns:a16="http://schemas.microsoft.com/office/drawing/2014/main" id="{77BA6A1D-BC5E-1EF8-BAA9-6ABC9EF7ECD5}"/>
              </a:ext>
            </a:extLst>
          </p:cNvPr>
          <p:cNvSpPr txBox="1"/>
          <p:nvPr/>
        </p:nvSpPr>
        <p:spPr>
          <a:xfrm>
            <a:off x="8538048" y="52927"/>
            <a:ext cx="912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QEE16621.1</a:t>
            </a:r>
          </a:p>
        </p:txBody>
      </p:sp>
      <p:sp>
        <p:nvSpPr>
          <p:cNvPr id="131" name="Rectangle 14">
            <a:extLst>
              <a:ext uri="{FF2B5EF4-FFF2-40B4-BE49-F238E27FC236}">
                <a16:creationId xmlns:a16="http://schemas.microsoft.com/office/drawing/2014/main" id="{BD2C9E82-7D3F-431F-1B55-67E91BFC7D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06164" y="1162142"/>
            <a:ext cx="3362400" cy="535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DRKYLNIID---AIVLQLDRKGKILYINVKGNKILGYRENEILGKNWFKTCIPHSKREE MERVFNKVING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33" name="Rectangle 15">
            <a:extLst>
              <a:ext uri="{FF2B5EF4-FFF2-40B4-BE49-F238E27FC236}">
                <a16:creationId xmlns:a16="http://schemas.microsoft.com/office/drawing/2014/main" id="{4CD5C1B7-DDCA-546C-706B-D41E3300DB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07995" y="1686684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TKRLASIVGTSSDSIVSMDKEGMIKSWNKGAERIYGYALEEVLEKS-ISMLIPPDRMEE IPNLIEKVVQG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35" name="CuadroTexto 134">
            <a:extLst>
              <a:ext uri="{FF2B5EF4-FFF2-40B4-BE49-F238E27FC236}">
                <a16:creationId xmlns:a16="http://schemas.microsoft.com/office/drawing/2014/main" id="{6CD5BA3C-949F-8422-64B8-DA01B8D00380}"/>
              </a:ext>
            </a:extLst>
          </p:cNvPr>
          <p:cNvSpPr txBox="1"/>
          <p:nvPr/>
        </p:nvSpPr>
        <p:spPr>
          <a:xfrm>
            <a:off x="8503240" y="1069575"/>
            <a:ext cx="928524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</p:txBody>
      </p:sp>
      <p:sp>
        <p:nvSpPr>
          <p:cNvPr id="137" name="CuadroTexto 136">
            <a:extLst>
              <a:ext uri="{FF2B5EF4-FFF2-40B4-BE49-F238E27FC236}">
                <a16:creationId xmlns:a16="http://schemas.microsoft.com/office/drawing/2014/main" id="{69048ED0-54F9-3F20-B758-1C03BBA340D3}"/>
              </a:ext>
            </a:extLst>
          </p:cNvPr>
          <p:cNvSpPr txBox="1"/>
          <p:nvPr/>
        </p:nvSpPr>
        <p:spPr>
          <a:xfrm>
            <a:off x="8511670" y="2121520"/>
            <a:ext cx="912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QEE16613.1</a:t>
            </a:r>
          </a:p>
        </p:txBody>
      </p:sp>
      <p:sp>
        <p:nvSpPr>
          <p:cNvPr id="139" name="Rectangle 16">
            <a:extLst>
              <a:ext uri="{FF2B5EF4-FFF2-40B4-BE49-F238E27FC236}">
                <a16:creationId xmlns:a16="http://schemas.microsoft.com/office/drawing/2014/main" id="{1F916DEB-0114-8CC9-DE31-DAD4B2165B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13182" y="2061693"/>
            <a:ext cx="3362400" cy="11509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M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RTPLNSIIGFTDVILerISGEINEEQDKYLTHVKTSAMLLLDLINDILDITKI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SGKMELNIEEVNLSQIISQVDTMIKPIYMKKSLIFEVQEIDKEKVIRVDRLRFKEILFNL LSNAVKYTKE-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KIMIKFSEEEEFWKFDVIDTGIGIKKENFDILFKDFRRIASkyVVAT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GTGLGLSLSKRLVEFHGGTISFTSTFGKGSKFTFTIPKQ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41" name="CuadroTexto 140">
            <a:extLst>
              <a:ext uri="{FF2B5EF4-FFF2-40B4-BE49-F238E27FC236}">
                <a16:creationId xmlns:a16="http://schemas.microsoft.com/office/drawing/2014/main" id="{412FAA72-B50F-D368-A78B-23596447DC08}"/>
              </a:ext>
            </a:extLst>
          </p:cNvPr>
          <p:cNvSpPr txBox="1"/>
          <p:nvPr/>
        </p:nvSpPr>
        <p:spPr>
          <a:xfrm>
            <a:off x="8935130" y="317147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</a:p>
        </p:txBody>
      </p:sp>
      <p:sp>
        <p:nvSpPr>
          <p:cNvPr id="143" name="Rectangle 17">
            <a:extLst>
              <a:ext uri="{FF2B5EF4-FFF2-40B4-BE49-F238E27FC236}">
                <a16:creationId xmlns:a16="http://schemas.microsoft.com/office/drawing/2014/main" id="{93352757-D60F-A8C5-1B87-690D0373E2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13182" y="3161742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KNQLANIVENSNDGIISAELDGTIRSWNKSAEVIFGFSSEEIIGKK--LDLIIPSNRFN EVKYIIDKIKQ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45" name="CuadroTexto 144">
            <a:extLst>
              <a:ext uri="{FF2B5EF4-FFF2-40B4-BE49-F238E27FC236}">
                <a16:creationId xmlns:a16="http://schemas.microsoft.com/office/drawing/2014/main" id="{6E64EFC1-037E-88DA-4AF4-9B75F6B3A4D3}"/>
              </a:ext>
            </a:extLst>
          </p:cNvPr>
          <p:cNvSpPr txBox="1"/>
          <p:nvPr/>
        </p:nvSpPr>
        <p:spPr>
          <a:xfrm>
            <a:off x="8404851" y="3636467"/>
            <a:ext cx="12025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WP_147661239.1</a:t>
            </a:r>
          </a:p>
        </p:txBody>
      </p:sp>
      <p:sp>
        <p:nvSpPr>
          <p:cNvPr id="147" name="Rectangle 1">
            <a:extLst>
              <a:ext uri="{FF2B5EF4-FFF2-40B4-BE49-F238E27FC236}">
                <a16:creationId xmlns:a16="http://schemas.microsoft.com/office/drawing/2014/main" id="{9F6B27B5-A4F1-2D7D-96D3-ABECCE75B5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42759" y="3494659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ILAVILGNVSLLQmDADHLSEEHNLIINDISTASERAKSIIKQLQEFSSQD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 -IRKEKAEIFDLSVIVDEVINFMKNTT-NRLIQKENSIPKNRYFIKGNPVEFNQVLLNLG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NSIHAIEEKkNGATTLDFIKIdisfpegeqkNTHIVVNFMDSGRGIPEKNLKQMFIPFF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KTgsgASKIKGRGLGLSMVYHIITNKFdGSINIESRVDHGTVFYITLPLID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49" name="CuadroTexto 148">
            <a:extLst>
              <a:ext uri="{FF2B5EF4-FFF2-40B4-BE49-F238E27FC236}">
                <a16:creationId xmlns:a16="http://schemas.microsoft.com/office/drawing/2014/main" id="{1BB66763-2090-986E-13C6-B926FABF557B}"/>
              </a:ext>
            </a:extLst>
          </p:cNvPr>
          <p:cNvSpPr txBox="1"/>
          <p:nvPr/>
        </p:nvSpPr>
        <p:spPr>
          <a:xfrm>
            <a:off x="8355883" y="4623534"/>
            <a:ext cx="1236300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3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4</a:t>
            </a:r>
          </a:p>
        </p:txBody>
      </p:sp>
      <p:sp>
        <p:nvSpPr>
          <p:cNvPr id="151" name="Rectangle 2">
            <a:extLst>
              <a:ext uri="{FF2B5EF4-FFF2-40B4-BE49-F238E27FC236}">
                <a16:creationId xmlns:a16="http://schemas.microsoft.com/office/drawing/2014/main" id="{659A8378-6448-A4B0-80D5-E5B527929E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42759" y="4767428"/>
            <a:ext cx="3362400" cy="2276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GYSQEDFLNHKTvYSDIVHPEDLP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KIRSESQHHVKNQ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53" name="Rectangle 3">
            <a:extLst>
              <a:ext uri="{FF2B5EF4-FFF2-40B4-BE49-F238E27FC236}">
                <a16:creationId xmlns:a16="http://schemas.microsoft.com/office/drawing/2014/main" id="{0F097F8A-049C-C564-02A1-4F7624B311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42759" y="5007266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RFRIVAENGSDLIYEFTSGGKKIAWFGDVENFYGLKSDEIPKNFDeVISRLHPSDQR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KITKQIEDLSAST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55" name="Rectangle 4">
            <a:extLst>
              <a:ext uri="{FF2B5EF4-FFF2-40B4-BE49-F238E27FC236}">
                <a16:creationId xmlns:a16="http://schemas.microsoft.com/office/drawing/2014/main" id="{5BA4C391-048A-2FF0-C121-333DAE5D85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42759" y="5341007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SRFRMVAENTSDLIYEYDYNDKNVKTFGGLESLLGISEKELNKSPKkFYDFIHDEDR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IIEKEMVKFLASK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57" name="Rectangle 5">
            <a:extLst>
              <a:ext uri="{FF2B5EF4-FFF2-40B4-BE49-F238E27FC236}">
                <a16:creationId xmlns:a16="http://schemas.microsoft.com/office/drawing/2014/main" id="{3757E617-0B00-559C-1DFE-AA84D890E1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42759" y="5674948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KERFRTVAQNVSDIIFEYDVKKHSVYWFGDIAEHLKIGDDEIPKRMTaFMKFIHPDDI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IKSEviiTRESRKNA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59" name="CuadroTexto 158">
            <a:extLst>
              <a:ext uri="{FF2B5EF4-FFF2-40B4-BE49-F238E27FC236}">
                <a16:creationId xmlns:a16="http://schemas.microsoft.com/office/drawing/2014/main" id="{13C88ABA-EB6E-74C2-A4DC-DCE1CBDEB306}"/>
              </a:ext>
            </a:extLst>
          </p:cNvPr>
          <p:cNvSpPr txBox="1"/>
          <p:nvPr/>
        </p:nvSpPr>
        <p:spPr>
          <a:xfrm>
            <a:off x="10641006" y="6170703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roup D</a:t>
            </a:r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CuadroTexto 160">
            <a:extLst>
              <a:ext uri="{FF2B5EF4-FFF2-40B4-BE49-F238E27FC236}">
                <a16:creationId xmlns:a16="http://schemas.microsoft.com/office/drawing/2014/main" id="{D47D8419-7D2F-8556-9C5D-69C69219BB61}"/>
              </a:ext>
            </a:extLst>
          </p:cNvPr>
          <p:cNvSpPr txBox="1"/>
          <p:nvPr/>
        </p:nvSpPr>
        <p:spPr>
          <a:xfrm>
            <a:off x="8643481" y="6567193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6295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Rectangle 6">
            <a:extLst>
              <a:ext uri="{FF2B5EF4-FFF2-40B4-BE49-F238E27FC236}">
                <a16:creationId xmlns:a16="http://schemas.microsoft.com/office/drawing/2014/main" id="{9DD214A9-2C9A-21C1-FFD3-A6BD0B435B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01486" y="6457963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TS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KTPLVSIKGFSNLLL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YSDKLDDYVLNTIGEikqGCIRLEDLIRDILKSAE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DSESVQLKKTSEDLSFLIRVCVNELKEFVKLRNHSINLQLQ-DDLITCFEKEQIHQVVSN LLTNAIKFTPI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VIELKSIKKEDSLIFSIKDNGIGFIDEEKERLFKQFGKIERYGQG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ivsDGSGLGLYISKKIIELHGGKIWLESEGRSkGSTFNFTLPLIS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65" name="CuadroTexto 164">
            <a:extLst>
              <a:ext uri="{FF2B5EF4-FFF2-40B4-BE49-F238E27FC236}">
                <a16:creationId xmlns:a16="http://schemas.microsoft.com/office/drawing/2014/main" id="{7530AB7A-9F3A-B455-B767-1B47B5608D76}"/>
              </a:ext>
            </a:extLst>
          </p:cNvPr>
          <p:cNvSpPr txBox="1"/>
          <p:nvPr/>
        </p:nvSpPr>
        <p:spPr>
          <a:xfrm>
            <a:off x="9044412" y="7779877"/>
            <a:ext cx="518155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3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4</a:t>
            </a:r>
          </a:p>
        </p:txBody>
      </p:sp>
      <p:sp>
        <p:nvSpPr>
          <p:cNvPr id="167" name="Rectangle 7">
            <a:extLst>
              <a:ext uri="{FF2B5EF4-FFF2-40B4-BE49-F238E27FC236}">
                <a16:creationId xmlns:a16="http://schemas.microsoft.com/office/drawing/2014/main" id="{63EF39B1-5214-E4C8-35FC-70235058AB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25541" y="7726899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TTLEQAILDAMSEAVFLIDLDNKILQCNKSTVKFLGKSKKDEIIGQTYWELLH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69" name="Rectangle 8">
            <a:extLst>
              <a:ext uri="{FF2B5EF4-FFF2-40B4-BE49-F238E27FC236}">
                <a16:creationId xmlns:a16="http://schemas.microsoft.com/office/drawing/2014/main" id="{5767538D-9281-F8F3-1674-E2C92EAD7C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01486" y="8052089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SNKFETVIENLIDMIAILDFKGEFLYVSPQVYNITGFTQEEIIGKNG-FTFIHPNDLDK VLKTMARLLKER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71" name="Rectangle 9">
            <a:extLst>
              <a:ext uri="{FF2B5EF4-FFF2-40B4-BE49-F238E27FC236}">
                <a16:creationId xmlns:a16="http://schemas.microsoft.com/office/drawing/2014/main" id="{37FD9B57-E7D0-D08A-D083-3A7A599FD0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25541" y="8349729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GVFRYFNKQFEEIIGFSREEINGWSSgeFLEAIHPDDR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DFVREQARKKQQGA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73" name="Rectangle 10">
            <a:extLst>
              <a:ext uri="{FF2B5EF4-FFF2-40B4-BE49-F238E27FC236}">
                <a16:creationId xmlns:a16="http://schemas.microsoft.com/office/drawing/2014/main" id="{340957B4-9EEA-C3B6-D259-C0E2979275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25541" y="8647986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DKVEYVNSTVLQIFEYSFEEVKNWSMkdLINIIHPDD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LLRKSrLEMRTNNS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75" name="CuadroTexto 174">
            <a:extLst>
              <a:ext uri="{FF2B5EF4-FFF2-40B4-BE49-F238E27FC236}">
                <a16:creationId xmlns:a16="http://schemas.microsoft.com/office/drawing/2014/main" id="{B01AF00A-3BF5-B1C3-4511-DABEBB358125}"/>
              </a:ext>
            </a:extLst>
          </p:cNvPr>
          <p:cNvSpPr txBox="1"/>
          <p:nvPr/>
        </p:nvSpPr>
        <p:spPr>
          <a:xfrm>
            <a:off x="8604432" y="9200061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6292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Rectangle 11">
            <a:extLst>
              <a:ext uri="{FF2B5EF4-FFF2-40B4-BE49-F238E27FC236}">
                <a16:creationId xmlns:a16="http://schemas.microsoft.com/office/drawing/2014/main" id="{EF3C0088-DCD6-76D1-F33D-09F6E55E94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69091" y="9102755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TS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KTPLVSIKGYADLLL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QHYEELDFYTISILYEmkrGCSRLESLIKDLLESSE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SEQIKLNKTEEDLTFLIRFCIKDLQGLVENRSHNLILEIQ-DRLKATFEKEKIYEVITN LLSNAIKYTPPS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EIRIKSEIKDNDIVISIQDNGIGLTREETLKLFKKFGKIERygqg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VDSEGSGLGLYISKKIIELHGGNIWVESEGRNlGTTFFFSLPIIK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79" name="CuadroTexto 178">
            <a:extLst>
              <a:ext uri="{FF2B5EF4-FFF2-40B4-BE49-F238E27FC236}">
                <a16:creationId xmlns:a16="http://schemas.microsoft.com/office/drawing/2014/main" id="{4C513548-FE8C-D929-31E7-7A90637D51E8}"/>
              </a:ext>
            </a:extLst>
          </p:cNvPr>
          <p:cNvSpPr txBox="1"/>
          <p:nvPr/>
        </p:nvSpPr>
        <p:spPr>
          <a:xfrm>
            <a:off x="8670372" y="10518957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3837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Rectangle 12">
            <a:extLst>
              <a:ext uri="{FF2B5EF4-FFF2-40B4-BE49-F238E27FC236}">
                <a16:creationId xmlns:a16="http://schemas.microsoft.com/office/drawing/2014/main" id="{5992405E-C9FE-BDB6-0046-48CFD39837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17272" y="10435924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A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KTPLISIKGYSDLILslYTDQLGSEIISYLNEISHGCERLQYIINDLLKSSRL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SIKLKSNLQKEDLPFLIKYCVNGMESLAKKRKQSIELNIH-DQLYVNIEKEEIHAVLSNL LSNAIKYTPP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KIEVKTDLKDDLVVISVTDNGIGFTEEQRKIVFKQFGKIERfgqglD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EIDGTGLGLYISKRIVESHGGKIWMESEGKNmGASFYFTLPTVK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83" name="Rectangle 13">
            <a:extLst>
              <a:ext uri="{FF2B5EF4-FFF2-40B4-BE49-F238E27FC236}">
                <a16:creationId xmlns:a16="http://schemas.microsoft.com/office/drawing/2014/main" id="{1535263D-C652-CF4D-C4D9-2536810A06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21661" y="11756711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YVNQQFAKIFGYSVEEILNWEFggYLKTVHLED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FVKNQaekkqkgIENVINRY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85" name="CuadroTexto 184">
            <a:extLst>
              <a:ext uri="{FF2B5EF4-FFF2-40B4-BE49-F238E27FC236}">
                <a16:creationId xmlns:a16="http://schemas.microsoft.com/office/drawing/2014/main" id="{9DC8787E-847D-C0EE-565F-0F32829279AC}"/>
              </a:ext>
            </a:extLst>
          </p:cNvPr>
          <p:cNvSpPr txBox="1"/>
          <p:nvPr/>
        </p:nvSpPr>
        <p:spPr>
          <a:xfrm>
            <a:off x="9059371" y="11810558"/>
            <a:ext cx="51815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</p:txBody>
      </p:sp>
      <p:sp>
        <p:nvSpPr>
          <p:cNvPr id="187" name="Rectangle 14">
            <a:extLst>
              <a:ext uri="{FF2B5EF4-FFF2-40B4-BE49-F238E27FC236}">
                <a16:creationId xmlns:a16="http://schemas.microsoft.com/office/drawing/2014/main" id="{39DF5138-0FD8-7CE1-688A-738ADD389F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22618" y="12244854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FRTIAEQSSAGFIIIQNSQIIYLNNAVSKVFGYSSEELKNISIidIFKFVHPEDR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89" name="CuadroTexto 188">
            <a:extLst>
              <a:ext uri="{FF2B5EF4-FFF2-40B4-BE49-F238E27FC236}">
                <a16:creationId xmlns:a16="http://schemas.microsoft.com/office/drawing/2014/main" id="{25BD78D8-9179-462B-056F-FD8DF3533CC4}"/>
              </a:ext>
            </a:extLst>
          </p:cNvPr>
          <p:cNvSpPr txBox="1"/>
          <p:nvPr/>
        </p:nvSpPr>
        <p:spPr>
          <a:xfrm>
            <a:off x="8718425" y="12814441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4257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Rectangle 15">
            <a:extLst>
              <a:ext uri="{FF2B5EF4-FFF2-40B4-BE49-F238E27FC236}">
                <a16:creationId xmlns:a16="http://schemas.microsoft.com/office/drawing/2014/main" id="{18EE040C-E1C5-89CE-EA45-2D3BEEC240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64269" y="12706140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A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KTPLISIKGFSELILssyKEELNPEVISNLTEIIK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CRRLQTIINDLLHASRL ETIDPKPRLEEEDLTFLIKYCVNELKSVIVKRRHSVNLEVH-DSLIARFEKEEIHDVISN LLINAIKYTPP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KINIKMELLEDTVIISVSDNGIGFNQYQKNSIFKQFGKIERYGQG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lgiDGTGLGLYISKRIVESHGGKIWMESEGINqGSTFYFSIPL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93" name="CuadroTexto 192">
            <a:extLst>
              <a:ext uri="{FF2B5EF4-FFF2-40B4-BE49-F238E27FC236}">
                <a16:creationId xmlns:a16="http://schemas.microsoft.com/office/drawing/2014/main" id="{A7C30D79-6332-ED9C-EAFC-F77B93143F30}"/>
              </a:ext>
            </a:extLst>
          </p:cNvPr>
          <p:cNvSpPr txBox="1"/>
          <p:nvPr/>
        </p:nvSpPr>
        <p:spPr>
          <a:xfrm>
            <a:off x="9116970" y="14094299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</a:p>
        </p:txBody>
      </p:sp>
      <p:sp>
        <p:nvSpPr>
          <p:cNvPr id="195" name="Rectangle 16">
            <a:extLst>
              <a:ext uri="{FF2B5EF4-FFF2-40B4-BE49-F238E27FC236}">
                <a16:creationId xmlns:a16="http://schemas.microsoft.com/office/drawing/2014/main" id="{CBF00C82-ADD0-FFF3-65B0-414F5C9315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63118" y="14022211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GEKYRRLFESSTDGIVSTDMEGRLIDFNKAFLEMLGYSKEELL</a:t>
            </a:r>
            <a:endParaRPr lang="es-MX" altLang="es-MX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7" name="CuadroTexto 196">
            <a:extLst>
              <a:ext uri="{FF2B5EF4-FFF2-40B4-BE49-F238E27FC236}">
                <a16:creationId xmlns:a16="http://schemas.microsoft.com/office/drawing/2014/main" id="{45E13697-F1B2-4B47-648E-2AF929F65750}"/>
              </a:ext>
            </a:extLst>
          </p:cNvPr>
          <p:cNvSpPr txBox="1"/>
          <p:nvPr/>
        </p:nvSpPr>
        <p:spPr>
          <a:xfrm>
            <a:off x="12536121" y="118232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1094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Rectangle 17">
            <a:extLst>
              <a:ext uri="{FF2B5EF4-FFF2-40B4-BE49-F238E27FC236}">
                <a16:creationId xmlns:a16="http://schemas.microsoft.com/office/drawing/2014/main" id="{774C6CF0-CD08-A454-0596-DD14C9B575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64588" y="3667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A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KTPLISIKGFSDLILslYSEQLDTGIVSKLEEINNGCERLQNLINNLLKTSRL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SAELKPKLQKEDLSFLIKFCVHELESLAETRKQSIKLDID-NELYANIEKEEIHDVLSNL LTNAIKYTPP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KIEIKTELKKDLVVVSVKDNGIGFTKDQKTKIFQQFGKIERYGQGld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giDGTGLGLYISKRIVKSHGGKIWMESEGKSrGSTFYFTLQTVK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01" name="CuadroTexto 200">
            <a:extLst>
              <a:ext uri="{FF2B5EF4-FFF2-40B4-BE49-F238E27FC236}">
                <a16:creationId xmlns:a16="http://schemas.microsoft.com/office/drawing/2014/main" id="{1DC59188-B68B-5BEF-94B5-2E4A7EB52B0E}"/>
              </a:ext>
            </a:extLst>
          </p:cNvPr>
          <p:cNvSpPr txBox="1"/>
          <p:nvPr/>
        </p:nvSpPr>
        <p:spPr>
          <a:xfrm>
            <a:off x="12912942" y="1310857"/>
            <a:ext cx="51815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</p:txBody>
      </p:sp>
      <p:sp>
        <p:nvSpPr>
          <p:cNvPr id="203" name="Rectangle 18">
            <a:extLst>
              <a:ext uri="{FF2B5EF4-FFF2-40B4-BE49-F238E27FC236}">
                <a16:creationId xmlns:a16="http://schemas.microsoft.com/office/drawing/2014/main" id="{419B77CD-EE07-296B-1D75-7CDF9DBD1E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66645" y="1286207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YRTLFESSKDGILFTNIEGKIMDCNQTYLDMLGYTLAEI----------------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05" name="Rectangle 19">
            <a:extLst>
              <a:ext uri="{FF2B5EF4-FFF2-40B4-BE49-F238E27FC236}">
                <a16:creationId xmlns:a16="http://schemas.microsoft.com/office/drawing/2014/main" id="{4ED84E9C-D5A4-241F-1868-EA4183124C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66644" y="1590998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RLHSEIMNNISEGVYLIRLENlIIVYANPRFEEMFGYEPNEMIGKYVvIVNAPTDKTP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EEIKDEIMGILKET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07" name="CuadroTexto 206">
            <a:extLst>
              <a:ext uri="{FF2B5EF4-FFF2-40B4-BE49-F238E27FC236}">
                <a16:creationId xmlns:a16="http://schemas.microsoft.com/office/drawing/2014/main" id="{AEBDEA8F-8CDB-9863-008D-2FE2FA3A1DE4}"/>
              </a:ext>
            </a:extLst>
          </p:cNvPr>
          <p:cNvSpPr txBox="1"/>
          <p:nvPr/>
        </p:nvSpPr>
        <p:spPr>
          <a:xfrm>
            <a:off x="12582676" y="2166173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3125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CuadroTexto 208">
            <a:extLst>
              <a:ext uri="{FF2B5EF4-FFF2-40B4-BE49-F238E27FC236}">
                <a16:creationId xmlns:a16="http://schemas.microsoft.com/office/drawing/2014/main" id="{43A749D1-6D86-A2A5-915A-3A2580AEF96A}"/>
              </a:ext>
            </a:extLst>
          </p:cNvPr>
          <p:cNvSpPr txBox="1"/>
          <p:nvPr/>
        </p:nvSpPr>
        <p:spPr>
          <a:xfrm>
            <a:off x="12573923" y="3535845"/>
            <a:ext cx="93006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. reg.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3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4</a:t>
            </a:r>
          </a:p>
        </p:txBody>
      </p:sp>
      <p:sp>
        <p:nvSpPr>
          <p:cNvPr id="211" name="Rectangle 20">
            <a:extLst>
              <a:ext uri="{FF2B5EF4-FFF2-40B4-BE49-F238E27FC236}">
                <a16:creationId xmlns:a16="http://schemas.microsoft.com/office/drawing/2014/main" id="{16B63785-BBB8-D170-5523-942F1216F9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25710" y="3324073"/>
            <a:ext cx="3362400" cy="6892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IIIIDDDDDVCDSLSLFLNKVGYKTETAQTGQEGINKITKEFYIVALL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LPDIEGTE LLKRLKEKHPKMDVIIMTGNASLNSAVQALNNGASGYILKPINLENLLTNLKNSI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13" name="Rectangle 21">
            <a:extLst>
              <a:ext uri="{FF2B5EF4-FFF2-40B4-BE49-F238E27FC236}">
                <a16:creationId xmlns:a16="http://schemas.microsoft.com/office/drawing/2014/main" id="{6B9ECF33-D90A-C705-8D7C-A5D8A42765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29252" y="1980280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I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NTPLISILNGSQYLLdfKNNKMSDDVSNIVKIIYQGGYRLREMVNNLITAYEL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TEQLIFKIKRENLIPIIKKCVEDLIFQAEKRKIFINLELP-TDLNVDVDKEMIKKAILNL LSNAVKNTLP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NIFIKSIEHHNFIDIIIRDTGVGLTDKEIPILFKKFGKIERygkgmD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IEGPGLGLYIANEIVKLHIGEILVKSKGRNkGSTFILRLFLK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15" name="Rectangle 22">
            <a:extLst>
              <a:ext uri="{FF2B5EF4-FFF2-40B4-BE49-F238E27FC236}">
                <a16:creationId xmlns:a16="http://schemas.microsoft.com/office/drawing/2014/main" id="{B0AED303-9BD3-06E0-E154-74DF05BD52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24148" y="3939180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YRELYENAPNAYFSVNPDKSIKGCNQPACELLGYNKKEILTMK-VFDLYYNSSEGL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KAKrlFKQFLEGK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17" name="Rectangle 23">
            <a:extLst>
              <a:ext uri="{FF2B5EF4-FFF2-40B4-BE49-F238E27FC236}">
                <a16:creationId xmlns:a16="http://schemas.microsoft.com/office/drawing/2014/main" id="{D9392483-D069-9E42-39EB-DB0CD73C91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25710" y="4243119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NNRLAAIVDSSDDAIIGKRLDGIITSWNTGATKIYGYMAKEVIGKP-INIMVPPDRQDE VTQILEKIKRR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19" name="Rectangle 24">
            <a:extLst>
              <a:ext uri="{FF2B5EF4-FFF2-40B4-BE49-F238E27FC236}">
                <a16:creationId xmlns:a16="http://schemas.microsoft.com/office/drawing/2014/main" id="{1619B32E-D347-52DA-DE7F-620EE616FC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10723" y="4547721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AKFRALFNNTNDSIFIHDGSSQFIEINKTACERLGYTREELLRLS-LKDIIPPGYKID LQTNIKTLYEK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21" name="Rectangle 25">
            <a:extLst>
              <a:ext uri="{FF2B5EF4-FFF2-40B4-BE49-F238E27FC236}">
                <a16:creationId xmlns:a16="http://schemas.microsoft.com/office/drawing/2014/main" id="{BCFEB241-871D-920E-F7BD-E71EEC403F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08369" y="4877210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VQNMITNISDVLLESEPNGILTYISPQIKNIIEYQSEELIGLN-FMDFVHIEDINS FKETASKALKTQ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23" name="CuadroTexto 222">
            <a:extLst>
              <a:ext uri="{FF2B5EF4-FFF2-40B4-BE49-F238E27FC236}">
                <a16:creationId xmlns:a16="http://schemas.microsoft.com/office/drawing/2014/main" id="{ACDEB745-A48E-9AEB-3C1E-8495961C64ED}"/>
              </a:ext>
            </a:extLst>
          </p:cNvPr>
          <p:cNvSpPr txBox="1"/>
          <p:nvPr/>
        </p:nvSpPr>
        <p:spPr>
          <a:xfrm>
            <a:off x="12603826" y="5394332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0441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Rectangle 26">
            <a:extLst>
              <a:ext uri="{FF2B5EF4-FFF2-40B4-BE49-F238E27FC236}">
                <a16:creationId xmlns:a16="http://schemas.microsoft.com/office/drawing/2014/main" id="{5EA31566-D28A-BEE2-D7E4-1FDE858AD3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26104" y="5240877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V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QTPIASMNLALQMLLenYKEQLSNNVIDLIEIIQRGERRLRSLIDNVIDASKV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LGKIKLYVQKENLIEIINDCIDVIYFMADKRQISISKDLPE-SLHLNFDKLRIEQVILNL LSNAIKYTPSS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NIYINIKESEQFADLFIKDTGIGLTEEEQGKIFKKFGKIERedcnsD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RNDGTGLGLYISNELVKLHDFSLRVDSEGRNkGSTFILRIPKN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27" name="CuadroTexto 226">
            <a:extLst>
              <a:ext uri="{FF2B5EF4-FFF2-40B4-BE49-F238E27FC236}">
                <a16:creationId xmlns:a16="http://schemas.microsoft.com/office/drawing/2014/main" id="{E4C3FD95-B87D-394A-A8CC-95712C24E2F3}"/>
              </a:ext>
            </a:extLst>
          </p:cNvPr>
          <p:cNvSpPr txBox="1"/>
          <p:nvPr/>
        </p:nvSpPr>
        <p:spPr>
          <a:xfrm>
            <a:off x="12687158" y="6706222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6428.1</a:t>
            </a:r>
            <a:endParaRPr lang="es-MX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Rectangle 27">
            <a:extLst>
              <a:ext uri="{FF2B5EF4-FFF2-40B4-BE49-F238E27FC236}">
                <a16:creationId xmlns:a16="http://schemas.microsoft.com/office/drawing/2014/main" id="{B148BC0D-D8CF-CAD2-902B-A791F2B682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09060" y="6528185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V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KTPLVSICGGSELLLelFGSDIKEEARELAEIIGKGGTRLKNLVDNLVDVTRI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YNKFELEIELINISDVLQDCAKEMMYLIKKREINFQLDLP-DTLIVNIDRVRIEQVVLNI LSNAIKNTPP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KVVMKLTKKKEWVEFLVNDSGIGLTREEMDRIFTRFGKIERYGPGl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idiQGSGLGLFISKEIIDLHKGHIWAESGGRDkGSTFTIKLPIS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31" name="CuadroTexto 230">
            <a:extLst>
              <a:ext uri="{FF2B5EF4-FFF2-40B4-BE49-F238E27FC236}">
                <a16:creationId xmlns:a16="http://schemas.microsoft.com/office/drawing/2014/main" id="{177A8949-0797-0D45-F9F0-09C75547D3B3}"/>
              </a:ext>
            </a:extLst>
          </p:cNvPr>
          <p:cNvSpPr txBox="1"/>
          <p:nvPr/>
        </p:nvSpPr>
        <p:spPr>
          <a:xfrm>
            <a:off x="12663094" y="7740934"/>
            <a:ext cx="946156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3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4</a:t>
            </a:r>
          </a:p>
        </p:txBody>
      </p:sp>
      <p:sp>
        <p:nvSpPr>
          <p:cNvPr id="233" name="Rectangle 28">
            <a:extLst>
              <a:ext uri="{FF2B5EF4-FFF2-40B4-BE49-F238E27FC236}">
                <a16:creationId xmlns:a16="http://schemas.microsoft.com/office/drawing/2014/main" id="{0FEA652E-FC62-CCFC-C46F-4EBB093854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12573" y="7835847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KGRYQRLIKSVKEGYYEVDLKGNFTFVNKALSRFIGYSQEEMIGQS-YKKITDRTKRKL VFKTFNKVFKT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35" name="Rectangle 29">
            <a:extLst>
              <a:ext uri="{FF2B5EF4-FFF2-40B4-BE49-F238E27FC236}">
                <a16:creationId xmlns:a16="http://schemas.microsoft.com/office/drawing/2014/main" id="{D6B6CA05-F84A-CA42-5435-D177D131BA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04934" y="8150093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DKYSNLFQHSNDGIFLHDLDGNITDVNRKVLEQLGYTKSEILSLK--VSQLHPTSEMV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SKKaFDKISEN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37" name="Rectangle 30">
            <a:extLst>
              <a:ext uri="{FF2B5EF4-FFF2-40B4-BE49-F238E27FC236}">
                <a16:creationId xmlns:a16="http://schemas.microsoft.com/office/drawing/2014/main" id="{90EC27A0-EF01-5EE5-C989-7E6E0D4090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04935" y="8473731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YRSMVNNLDLGFYQVDWDGNLLNYNPAFASLFGFEPDEDITNVNVKEF-------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39" name="Rectangle 31">
            <a:extLst>
              <a:ext uri="{FF2B5EF4-FFF2-40B4-BE49-F238E27FC236}">
                <a16:creationId xmlns:a16="http://schemas.microsoft.com/office/drawing/2014/main" id="{3DC598CD-04A3-14C6-C02F-5BF935B19A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88893" y="8771725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SKYRNLIESVPFSIALINLGGRVIYCNPATEKLLGFKEEELVGYEFrNLPIINQKYLP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MMLKRFKKAANG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41" name="CuadroTexto 240">
            <a:extLst>
              <a:ext uri="{FF2B5EF4-FFF2-40B4-BE49-F238E27FC236}">
                <a16:creationId xmlns:a16="http://schemas.microsoft.com/office/drawing/2014/main" id="{6AAAC0AB-D526-4DFD-05C6-43C03CE2B3B2}"/>
              </a:ext>
            </a:extLst>
          </p:cNvPr>
          <p:cNvSpPr txBox="1"/>
          <p:nvPr/>
        </p:nvSpPr>
        <p:spPr>
          <a:xfrm>
            <a:off x="12736719" y="9366182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4457.1</a:t>
            </a:r>
          </a:p>
        </p:txBody>
      </p:sp>
      <p:sp>
        <p:nvSpPr>
          <p:cNvPr id="243" name="Rectangle 32">
            <a:extLst>
              <a:ext uri="{FF2B5EF4-FFF2-40B4-BE49-F238E27FC236}">
                <a16:creationId xmlns:a16="http://schemas.microsoft.com/office/drawing/2014/main" id="{E3FE0017-9671-4F58-E46A-C84507E9CF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65524" y="9193946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V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KTPLVSICGGSELLLelFGSDIKEEARELAEMIGKGGTRLKNLVDNLLDVTRI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YNKFELEKESINISEVLQDCAEEMMYLTKKREINFQLDLP-DTLIVNIDRVRIEQVVLNI LTNAIKNTPP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KVFMKLTKKKEWVEFSVNDSGIGLTREEMDRIFTRFGKIERYGPGl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idiQGSGLGLFISKEIIDLHKGQIWAESGGRDkGSTFTIKLPIS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45" name="CuadroTexto 244">
            <a:extLst>
              <a:ext uri="{FF2B5EF4-FFF2-40B4-BE49-F238E27FC236}">
                <a16:creationId xmlns:a16="http://schemas.microsoft.com/office/drawing/2014/main" id="{35536A39-3FD0-AB71-8F54-CE22B372BEF6}"/>
              </a:ext>
            </a:extLst>
          </p:cNvPr>
          <p:cNvSpPr txBox="1"/>
          <p:nvPr/>
        </p:nvSpPr>
        <p:spPr>
          <a:xfrm>
            <a:off x="12712655" y="10384852"/>
            <a:ext cx="93012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</p:txBody>
      </p:sp>
      <p:sp>
        <p:nvSpPr>
          <p:cNvPr id="247" name="Rectangle 33">
            <a:extLst>
              <a:ext uri="{FF2B5EF4-FFF2-40B4-BE49-F238E27FC236}">
                <a16:creationId xmlns:a16="http://schemas.microsoft.com/office/drawing/2014/main" id="{0367F89A-30A1-04A1-01B4-CE9E65087F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47462" y="10484477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YRSMVNNLDLGFYQVDWDGNLLNYNPAFASLFGFEPDE-----------------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49" name="Rectangle 34">
            <a:extLst>
              <a:ext uri="{FF2B5EF4-FFF2-40B4-BE49-F238E27FC236}">
                <a16:creationId xmlns:a16="http://schemas.microsoft.com/office/drawing/2014/main" id="{4BB945E0-209B-879B-BC79-0D71A09E12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60453" y="10812981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SRYRNLIESVPFSIALIDQGGKVIYCNPATEKLLGYKREELIGNEFrSLPVINQKYLP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MMLNGFKKVANG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51" name="CuadroTexto 250">
            <a:extLst>
              <a:ext uri="{FF2B5EF4-FFF2-40B4-BE49-F238E27FC236}">
                <a16:creationId xmlns:a16="http://schemas.microsoft.com/office/drawing/2014/main" id="{5DCD2E33-EBE8-ACA2-FE2C-2A98C5BFCE26}"/>
              </a:ext>
            </a:extLst>
          </p:cNvPr>
          <p:cNvSpPr txBox="1"/>
          <p:nvPr/>
        </p:nvSpPr>
        <p:spPr>
          <a:xfrm>
            <a:off x="12744290" y="11326006"/>
            <a:ext cx="9220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6009.1</a:t>
            </a:r>
          </a:p>
        </p:txBody>
      </p:sp>
      <p:sp>
        <p:nvSpPr>
          <p:cNvPr id="253" name="Rectangle 35">
            <a:extLst>
              <a:ext uri="{FF2B5EF4-FFF2-40B4-BE49-F238E27FC236}">
                <a16:creationId xmlns:a16="http://schemas.microsoft.com/office/drawing/2014/main" id="{60E9C3CE-A97E-7913-4492-599E535D18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30734" y="11179597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V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KTPMTSIYGSIQILLtiYNKDLSEEVLNYVKIGHRGCLRLKQLIENLLDASRL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SKKFELSLLKENLVEIIVDCVEDLNYLVHNRHLLITLDLP-DEIQADIDSLRFRQVITNI ISNAIKNTPK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GEIFIHIIEDADKIDILIRDTGVGLTKQEQEKLFGKFGKIERygmdlD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IEGCGLGLYISKEIIELHKGQILVESEGRNkGSTFTIRLFK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55" name="CuadroTexto 254">
            <a:extLst>
              <a:ext uri="{FF2B5EF4-FFF2-40B4-BE49-F238E27FC236}">
                <a16:creationId xmlns:a16="http://schemas.microsoft.com/office/drawing/2014/main" id="{E22DC39E-4963-DC62-45A3-C9B34C82FC6B}"/>
              </a:ext>
            </a:extLst>
          </p:cNvPr>
          <p:cNvSpPr txBox="1"/>
          <p:nvPr/>
        </p:nvSpPr>
        <p:spPr>
          <a:xfrm>
            <a:off x="13011825" y="12534540"/>
            <a:ext cx="518154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3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4</a:t>
            </a:r>
          </a:p>
        </p:txBody>
      </p:sp>
      <p:sp>
        <p:nvSpPr>
          <p:cNvPr id="257" name="Rectangle 36">
            <a:extLst>
              <a:ext uri="{FF2B5EF4-FFF2-40B4-BE49-F238E27FC236}">
                <a16:creationId xmlns:a16="http://schemas.microsoft.com/office/drawing/2014/main" id="{5B3B5BED-F5E5-583C-4A07-57393E0815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19806" y="12448305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IDYADLFEYSLDFLFILDLKGNIIDINNVATETLGYSRREILNMN-ITEFLLEEEIEQ LLNKRKELINI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59" name="Rectangle 38">
            <a:extLst>
              <a:ext uri="{FF2B5EF4-FFF2-40B4-BE49-F238E27FC236}">
                <a16:creationId xmlns:a16="http://schemas.microsoft.com/office/drawing/2014/main" id="{7F136D2B-4DAE-D33F-545A-21B8572C1D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18956" y="13086603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GVFKYVNDVVSEIIGYDIQDILNWSQneFFNKIHPSDV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PIALKRFQQMQLG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61" name="Rectangle 39">
            <a:extLst>
              <a:ext uri="{FF2B5EF4-FFF2-40B4-BE49-F238E27FC236}">
                <a16:creationId xmlns:a16="http://schemas.microsoft.com/office/drawing/2014/main" id="{8903B7D7-79AB-7C5A-A8EE-322B645479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09431" y="13432693"/>
            <a:ext cx="3362400" cy="381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FRTIAEQSFMGIIIVQEGKLKYLNKALAKMLEYPFEEMIKWSDkeMAEIVHPDDLEYIQKRLQSNREGT</a:t>
            </a:r>
            <a:endParaRPr lang="es-MX" altLang="es-MX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63" name="CuadroTexto 262">
            <a:extLst>
              <a:ext uri="{FF2B5EF4-FFF2-40B4-BE49-F238E27FC236}">
                <a16:creationId xmlns:a16="http://schemas.microsoft.com/office/drawing/2014/main" id="{C46303FB-189B-C442-9487-049B5E393E74}"/>
              </a:ext>
            </a:extLst>
          </p:cNvPr>
          <p:cNvSpPr txBox="1"/>
          <p:nvPr/>
        </p:nvSpPr>
        <p:spPr>
          <a:xfrm>
            <a:off x="12743750" y="13927108"/>
            <a:ext cx="9220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KKK45741.1</a:t>
            </a:r>
          </a:p>
        </p:txBody>
      </p:sp>
      <p:sp>
        <p:nvSpPr>
          <p:cNvPr id="265" name="Rectangle 40">
            <a:extLst>
              <a:ext uri="{FF2B5EF4-FFF2-40B4-BE49-F238E27FC236}">
                <a16:creationId xmlns:a16="http://schemas.microsoft.com/office/drawing/2014/main" id="{EB869B43-E6C5-5CEC-4440-92A967725B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15671" y="13778095"/>
            <a:ext cx="3362400" cy="1304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I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KTPLTSIYTTTNLLLnvYKEEFSNKILDFIKMINEGGERLKELVDNMLDVYDIE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SNMIKLNFKAHNLVDILEMSITTLQPQIVKRQHKVEINLP-HEVYMDVDYDRIKQVFLNL LINALKYTPP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KIFVQLQENNSHIDITIKDFGVGFTEQEKGKLFMKFGKIERygkgmN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TEGAGFGLYIAKELTRLHNGELILKSEGRNkGSTFIIRLFKEI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67" name="CuadroTexto 266">
            <a:extLst>
              <a:ext uri="{FF2B5EF4-FFF2-40B4-BE49-F238E27FC236}">
                <a16:creationId xmlns:a16="http://schemas.microsoft.com/office/drawing/2014/main" id="{30FEA389-D597-7AF6-6770-550D990423AC}"/>
              </a:ext>
            </a:extLst>
          </p:cNvPr>
          <p:cNvSpPr txBox="1"/>
          <p:nvPr/>
        </p:nvSpPr>
        <p:spPr>
          <a:xfrm>
            <a:off x="12533407" y="15093034"/>
            <a:ext cx="9220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</a:p>
        </p:txBody>
      </p:sp>
      <p:sp>
        <p:nvSpPr>
          <p:cNvPr id="269" name="Rectangle 41">
            <a:extLst>
              <a:ext uri="{FF2B5EF4-FFF2-40B4-BE49-F238E27FC236}">
                <a16:creationId xmlns:a16="http://schemas.microsoft.com/office/drawing/2014/main" id="{5EE6048B-0474-05F4-37E5-62B8701896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01246" y="15061678"/>
            <a:ext cx="3362400" cy="535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36501" rIns="91440" bIns="36501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FRTIAE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SVMGILIVQDGVIKYANESLSEINEYSIQEMMNWSPseLTKAIHPDER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GIINERIEKISLGS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271" name="Rectangle 2">
            <a:extLst>
              <a:ext uri="{FF2B5EF4-FFF2-40B4-BE49-F238E27FC236}">
                <a16:creationId xmlns:a16="http://schemas.microsoft.com/office/drawing/2014/main" id="{B123CE30-4F78-51F9-31FE-E44F12EC2C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21209" y="12800766"/>
            <a:ext cx="3647152" cy="3045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FRTLFEKANDGILLSDAETwRIFTGNQKICQMLGYSLEEI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1992069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CuadroTexto 26">
            <a:extLst>
              <a:ext uri="{FF2B5EF4-FFF2-40B4-BE49-F238E27FC236}">
                <a16:creationId xmlns:a16="http://schemas.microsoft.com/office/drawing/2014/main" id="{FEEC3F98-BB2D-15D0-6D96-77C988F50093}"/>
              </a:ext>
            </a:extLst>
          </p:cNvPr>
          <p:cNvSpPr txBox="1"/>
          <p:nvPr/>
        </p:nvSpPr>
        <p:spPr>
          <a:xfrm>
            <a:off x="7864443" y="955711"/>
            <a:ext cx="2271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Heimdallarchaeota</a:t>
            </a:r>
            <a:endParaRPr lang="en-US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F47C643D-1B1B-7574-4C18-440E0580A424}"/>
              </a:ext>
            </a:extLst>
          </p:cNvPr>
          <p:cNvSpPr txBox="1"/>
          <p:nvPr/>
        </p:nvSpPr>
        <p:spPr>
          <a:xfrm>
            <a:off x="2988465" y="7544201"/>
            <a:ext cx="1281185" cy="24006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OLS29276.1</a:t>
            </a: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5DA40EDB-8167-DDDE-9165-0540752ED97D}"/>
              </a:ext>
            </a:extLst>
          </p:cNvPr>
          <p:cNvSpPr txBox="1"/>
          <p:nvPr/>
        </p:nvSpPr>
        <p:spPr>
          <a:xfrm>
            <a:off x="2988465" y="1894456"/>
            <a:ext cx="1366143" cy="37856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OLS28176.1</a:t>
            </a: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1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2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3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4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5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6</a:t>
            </a:r>
          </a:p>
        </p:txBody>
      </p:sp>
      <p:sp>
        <p:nvSpPr>
          <p:cNvPr id="32" name="Rectangle 1">
            <a:extLst>
              <a:ext uri="{FF2B5EF4-FFF2-40B4-BE49-F238E27FC236}">
                <a16:creationId xmlns:a16="http://schemas.microsoft.com/office/drawing/2014/main" id="{543E2E59-FA47-79B8-EDF7-56E62FA52D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3592436"/>
            <a:ext cx="3868867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TNLLEFIIDNSPEIIFINDLDG--NFIYSNKLELLGYSKSELENRN-LFEFIHPEDQDN IDRALKNIRSGS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34" name="Rectangle 3">
            <a:extLst>
              <a:ext uri="{FF2B5EF4-FFF2-40B4-BE49-F238E27FC236}">
                <a16:creationId xmlns:a16="http://schemas.microsoft.com/office/drawing/2014/main" id="{6584C49B-E9D2-5982-E840-7EDC339BD1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2944" y="3963335"/>
            <a:ext cx="4261865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EKFRKVFENSNDAIFWSDAETgIILNCNYKASKLLERSKEEICGQH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HSFIHPK-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35" name="Rectangle 4">
            <a:extLst>
              <a:ext uri="{FF2B5EF4-FFF2-40B4-BE49-F238E27FC236}">
                <a16:creationId xmlns:a16="http://schemas.microsoft.com/office/drawing/2014/main" id="{8BB6E07D-6453-DBCA-1FB7-8705DE805D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4359848"/>
            <a:ext cx="4005192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NKYRNVFESSNVGITISTFDSKILEANESCEFILGYPYEEFINLKVDEIFVNLEDGKE IAKILKQ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36" name="Rectangle 5">
            <a:extLst>
              <a:ext uri="{FF2B5EF4-FFF2-40B4-BE49-F238E27FC236}">
                <a16:creationId xmlns:a16="http://schemas.microsoft.com/office/drawing/2014/main" id="{324FD297-C2AC-2935-7E22-51641A5D86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7006" y="4704455"/>
            <a:ext cx="4261865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QKLYQDLYDSAPDMYISVDGKThYVIRCNQATARNLRYTKDEIINKS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ILNLYHPSVKD RVKLLFETNPEAD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37" name="Rectangle 6">
            <a:extLst>
              <a:ext uri="{FF2B5EF4-FFF2-40B4-BE49-F238E27FC236}">
                <a16:creationId xmlns:a16="http://schemas.microsoft.com/office/drawing/2014/main" id="{B1BB85FF-B679-AB3C-4CE5-5419121281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5014963"/>
            <a:ext cx="4005192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NIRYQQLFSSSNAGISLSTLDGRIVEINEAWTKIVGYTHDEFLNMTIADIYVNEEEREK LISI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38" name="Rectangle 7">
            <a:extLst>
              <a:ext uri="{FF2B5EF4-FFF2-40B4-BE49-F238E27FC236}">
                <a16:creationId xmlns:a16="http://schemas.microsoft.com/office/drawing/2014/main" id="{7ACCEA7A-1EDB-8446-4098-5134BCCE68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19770" y="5362708"/>
            <a:ext cx="4261865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QQLYQDLYDNAPDMFCSVHAKTaKVVTCNQTLATNLGYTKEEIIGQS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VFNLYHPS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39" name="Rectangle 8">
            <a:extLst>
              <a:ext uri="{FF2B5EF4-FFF2-40B4-BE49-F238E27FC236}">
                <a16:creationId xmlns:a16="http://schemas.microsoft.com/office/drawing/2014/main" id="{F8C03919-EB20-66A6-8D61-4A238EACE7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1795703"/>
            <a:ext cx="3957098" cy="10739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YNNLLVGILGNVNLMQlDKNLNDNLENSLLEIEKA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THRASNLTKQLLTFSK--- -GGAPITNPESIKTIIDESISFVLRGS---NSKSQITYSDKLPIVEVDAGQISQLINNIV INAVQSMPE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IKIEVSEInilsgsnlplnkGKYVKIVIQDEGIGIKEEALPHIFDPY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YTTKS----TGSGLGLATSYSIVKRHNGYIEVESKEGKGATFTIFLPLSD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0" name="Rectangle 9">
            <a:extLst>
              <a:ext uri="{FF2B5EF4-FFF2-40B4-BE49-F238E27FC236}">
                <a16:creationId xmlns:a16="http://schemas.microsoft.com/office/drawing/2014/main" id="{B3C086F8-0871-D0DA-19F1-590D0D5E6A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2879993"/>
            <a:ext cx="3957098" cy="766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VLFMDDDALIRKTMKELLKELGFTVDLVDDGEKAIDLYRKSIeennpFSLTIM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TVP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GGNEAIKQLIKIDPHIVAIVSSGYSIDPVLADFKKHGFKGRLVKPYTLNQLKKVISQC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1" name="Rectangle 10">
            <a:extLst>
              <a:ext uri="{FF2B5EF4-FFF2-40B4-BE49-F238E27FC236}">
                <a16:creationId xmlns:a16="http://schemas.microsoft.com/office/drawing/2014/main" id="{1811DC1F-8E2B-526B-105F-6F9DE513D6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9152362"/>
            <a:ext cx="3891487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NELFILAIHNSPDVIWVKDLNSKYLMVNTSYLKFYNKSEDEIIGKVD-SDIFSKELSEL FLKSDKEVLQRQ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2" name="Rectangle 11">
            <a:extLst>
              <a:ext uri="{FF2B5EF4-FFF2-40B4-BE49-F238E27FC236}">
                <a16:creationId xmlns:a16="http://schemas.microsoft.com/office/drawing/2014/main" id="{965469CC-3E54-4180-8B09-1D8508D98C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9595417"/>
            <a:ext cx="3836816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NAILNMIFEHAPDPIFVKDLNGIYTNVNRAFADFHGLTVRSAQGKTD-NDLFDSEIAEK FLIEDKRIIDT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3" name="Rectangle 12">
            <a:extLst>
              <a:ext uri="{FF2B5EF4-FFF2-40B4-BE49-F238E27FC236}">
                <a16:creationId xmlns:a16="http://schemas.microsoft.com/office/drawing/2014/main" id="{AE086A85-7DE2-46C9-C271-81E058754E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7324995"/>
            <a:ext cx="3989149" cy="1227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A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LNNTLSGVMGYASLILTQESLDENKVYLEKIINA-SKRAAKLIDRLQTFTKKHVD ----QLISVDLNSIISDTYALINPSI-QAKLKINLDLDSDLMELDGDPTQISQVVMNLLF NAIDSIE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GKISISTTMAsladldsyimkspnikpGEFVKLTINDTGKGIPEELMDK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FEPFFTTKIDGTVKGNGLGLTIVYNVVTNHGGVIDVKSEINEGTTFDVYFPIGN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4" name="Rectangle 13">
            <a:extLst>
              <a:ext uri="{FF2B5EF4-FFF2-40B4-BE49-F238E27FC236}">
                <a16:creationId xmlns:a16="http://schemas.microsoft.com/office/drawing/2014/main" id="{F97B65A5-F3A3-BF04-2170-71C38B162E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8439808"/>
            <a:ext cx="3891487" cy="61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LIVEDEEDVRILLGRMLTILGYTSISATNGLEGVAIFEERHneIDLVFL</a:t>
            </a:r>
            <a:r>
              <a:rPr lang="es-MX" altLang="es-MX" sz="1000" b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VMPEMDG KDTFLQMKLIDSDVKVIISSGYTREKFSEILD-LGISAILEKPYSINELSETINSVL</a:t>
            </a:r>
            <a:r>
              <a:rPr lang="es-MX" altLang="es-MX" sz="100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1751E9E5-0B18-0703-A3EE-93C404CF4AA2}"/>
              </a:ext>
            </a:extLst>
          </p:cNvPr>
          <p:cNvSpPr txBox="1"/>
          <p:nvPr/>
        </p:nvSpPr>
        <p:spPr>
          <a:xfrm>
            <a:off x="9065798" y="4690406"/>
            <a:ext cx="1378967" cy="20928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OLS20714.1</a:t>
            </a: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CHASE</a:t>
            </a:r>
          </a:p>
        </p:txBody>
      </p:sp>
      <p:sp>
        <p:nvSpPr>
          <p:cNvPr id="47" name="Rectangle 14">
            <a:extLst>
              <a:ext uri="{FF2B5EF4-FFF2-40B4-BE49-F238E27FC236}">
                <a16:creationId xmlns:a16="http://schemas.microsoft.com/office/drawing/2014/main" id="{0994C265-7568-5C53-282D-351D8CC9D3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6487457"/>
            <a:ext cx="3917237" cy="61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ISWVYPFESNQGALNRSITTLadGSINDAYIEARDTKQVRITPV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SLFQGV---KGLASYLPIIFEN---------QLVGLFNVVFQIDTLVDVV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8" name="Rectangle 15">
            <a:extLst>
              <a:ext uri="{FF2B5EF4-FFF2-40B4-BE49-F238E27FC236}">
                <a16:creationId xmlns:a16="http://schemas.microsoft.com/office/drawing/2014/main" id="{F94EC18A-1AEF-4FC4-A50B-2E8EC74079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4551202"/>
            <a:ext cx="3917238" cy="1227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LLMGLQANFSILTdiqlelllnsssIDKTVTQEMKETSLSIQELLERSVNLT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SQILSFSR----QSVIDLEFINMKTAIENTLRIITQSS-DKRIVITKTLEKEPMFIYGNT SKISQLIMNVILNSIEAQPN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LDIDMRISninsyhiqlgeldrsigydlEKMIVLQ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RDSGSGIAKEDLDKLFVPFFTTK-TKSKKGTGLGLAIAYRSVRTMFGDITIDSVQAEGTT VNIFLPLIT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49" name="Rectangle 16">
            <a:extLst>
              <a:ext uri="{FF2B5EF4-FFF2-40B4-BE49-F238E27FC236}">
                <a16:creationId xmlns:a16="http://schemas.microsoft.com/office/drawing/2014/main" id="{A768CAB1-9B3A-1B76-8075-8A907C8259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5871849"/>
            <a:ext cx="4021265" cy="61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IMIVDDETAIRRGLRIYLKDKNQAISEFENGIDAIKFYEENEnFDLVIL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NLPGMSG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QVQEKIREITPNQKILFITGYSEDSISVDP--NSNIYILLKPFTKESFLSKIGEI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48A9F35E-3750-608A-CA25-2975FBD95F50}"/>
              </a:ext>
            </a:extLst>
          </p:cNvPr>
          <p:cNvSpPr txBox="1"/>
          <p:nvPr/>
        </p:nvSpPr>
        <p:spPr>
          <a:xfrm>
            <a:off x="2988465" y="10314408"/>
            <a:ext cx="1391791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OLS20551.1</a:t>
            </a: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17">
            <a:extLst>
              <a:ext uri="{FF2B5EF4-FFF2-40B4-BE49-F238E27FC236}">
                <a16:creationId xmlns:a16="http://schemas.microsoft.com/office/drawing/2014/main" id="{CFBA528C-E43A-61B1-10D5-A37CE42A33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10188320"/>
            <a:ext cx="3836816" cy="1227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A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FNNLLAIIVGNLSLVEiEMDNFTEIQKKLIINTLKASERATKLIKQFQNLSK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 -GTLSEKSCLDLYNITEEVFQFLQNIS--KDIEKVITFPAGEFFVLGNSTELNQVFINLS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NSLFAIRAKgvdvkdqnGNFIKVSAEKNnfigknllkskqddkrtkVNYIKIVFEDSGI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FTKESLRRVFEPLYTTKKEGSVKGSGLGMTYVYNVITADNrGRITVENRPDQGARITLY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LPEC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3" name="Rectangle 18">
            <a:extLst>
              <a:ext uri="{FF2B5EF4-FFF2-40B4-BE49-F238E27FC236}">
                <a16:creationId xmlns:a16="http://schemas.microsoft.com/office/drawing/2014/main" id="{7EF92D7A-81CF-0FC2-33B4-7F2E9922F3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11433312"/>
            <a:ext cx="3766012" cy="766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ILVVDDEAELRDLLIICLQKVGYSVITAENGKEALEIFKQKQssIDLILL</a:t>
            </a:r>
            <a:r>
              <a:rPr lang="es-MX" altLang="es-MX" sz="1000" b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VMPIMSG IEVVEEISKLTPEKKIIIMSGHFQDQKMNNIELhEKILAYLIKPFSMPMLLNKIRDGL</a:t>
            </a:r>
            <a:r>
              <a:rPr lang="es-MX" altLang="es-MX" sz="100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AB0A67F5-71FC-A4D7-253D-BE550EBA4967}"/>
              </a:ext>
            </a:extLst>
          </p:cNvPr>
          <p:cNvSpPr txBox="1"/>
          <p:nvPr/>
        </p:nvSpPr>
        <p:spPr>
          <a:xfrm>
            <a:off x="2988465" y="6131188"/>
            <a:ext cx="1455911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OLS17069.1</a:t>
            </a: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19">
            <a:extLst>
              <a:ext uri="{FF2B5EF4-FFF2-40B4-BE49-F238E27FC236}">
                <a16:creationId xmlns:a16="http://schemas.microsoft.com/office/drawing/2014/main" id="{51F96624-AF8F-0E09-B40E-181367CBAE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6104434"/>
            <a:ext cx="3727868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EENnspkngKSYLCISIKDNGSGILEEYKNKIFEPFFTTKS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 --DGFGIGLSSSYDQILEMGGLMDFSSKSNEGSIFNIYLPITS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7" name="Rectangle 20">
            <a:extLst>
              <a:ext uri="{FF2B5EF4-FFF2-40B4-BE49-F238E27FC236}">
                <a16:creationId xmlns:a16="http://schemas.microsoft.com/office/drawing/2014/main" id="{B03C1A37-48D6-3EA2-3AA5-239E9CAC96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5118" y="6474496"/>
            <a:ext cx="3726604" cy="766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ILVVDDEEQIRLLMKQNLEEKGFNVITAENGLLAYEILENESekISGVLT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RMPIMR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TELYEKVIDKNPQMKFVIMTGYFDEIIDNDQYQ--NILKIKKPILEDDLIRICNELQ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54B2936A-4FF9-6225-EC34-CA3981AF3501}"/>
              </a:ext>
            </a:extLst>
          </p:cNvPr>
          <p:cNvSpPr txBox="1"/>
          <p:nvPr/>
        </p:nvSpPr>
        <p:spPr>
          <a:xfrm>
            <a:off x="8849231" y="7196899"/>
            <a:ext cx="1582549" cy="2554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OLS17067.1</a:t>
            </a: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21">
            <a:extLst>
              <a:ext uri="{FF2B5EF4-FFF2-40B4-BE49-F238E27FC236}">
                <a16:creationId xmlns:a16="http://schemas.microsoft.com/office/drawing/2014/main" id="{D236E32D-1D41-FA94-5921-499BC293E6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7099757"/>
            <a:ext cx="3726604" cy="10739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S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LLTSIIGYSSLLQEYVKDNKKGLSILNEIINSSKKVTSIIDQLLSFSKNRID ----ILEEIEVNEIILNFQNMLQLLL-DDNVNLDIRISREPGFILIDKVRLEQIILNLVI NSSQAMPN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ISINTELIevtkifndkndgklAYNVMISVEDDGVGMNNKTINQIFEP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FFSTKK----DGTGLGLTTVYNIVKQYDGKISVNSKINIGTSFRITFPGIR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61" name="Rectangle 22">
            <a:extLst>
              <a:ext uri="{FF2B5EF4-FFF2-40B4-BE49-F238E27FC236}">
                <a16:creationId xmlns:a16="http://schemas.microsoft.com/office/drawing/2014/main" id="{FA45AFFE-1D7E-1CD8-D59D-0B17D34484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8201998"/>
            <a:ext cx="3578289" cy="766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LLVEDNASIRKMIFEVLTEEGYITETASDAQEGKRVLANLKnkPNLIIS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MPGTN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VDFVKSIIDDLPNTQILFITGYSDIIISDVIEK-VKYEILPKPFKIEDLITIVRLM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62" name="Rectangle 23">
            <a:extLst>
              <a:ext uri="{FF2B5EF4-FFF2-40B4-BE49-F238E27FC236}">
                <a16:creationId xmlns:a16="http://schemas.microsoft.com/office/drawing/2014/main" id="{476B1F11-5F78-EA5B-33BD-0129A16AB9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9074875"/>
            <a:ext cx="3726604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ALYKSIMDNASDGIILINNDGRVNWVNRAACNLFGYSDKEILNNN--ITFLMPEKYRE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HVKgLNNFVKTG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37E1BF0B-3D20-4D4D-5BEF-5F12982A6F5B}"/>
              </a:ext>
            </a:extLst>
          </p:cNvPr>
          <p:cNvSpPr txBox="1"/>
          <p:nvPr/>
        </p:nvSpPr>
        <p:spPr>
          <a:xfrm>
            <a:off x="8849231" y="9870801"/>
            <a:ext cx="1582549" cy="2554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OLS17051.1</a:t>
            </a: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C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162B56DA-EF85-A04A-3B79-E8F12EB6380B}"/>
              </a:ext>
            </a:extLst>
          </p:cNvPr>
          <p:cNvSpPr txBox="1"/>
          <p:nvPr/>
        </p:nvSpPr>
        <p:spPr>
          <a:xfrm>
            <a:off x="8849231" y="1891404"/>
            <a:ext cx="1596976" cy="27084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OLS32128.1</a:t>
            </a: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sp</a:t>
            </a:r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s-MX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24">
            <a:extLst>
              <a:ext uri="{FF2B5EF4-FFF2-40B4-BE49-F238E27FC236}">
                <a16:creationId xmlns:a16="http://schemas.microsoft.com/office/drawing/2014/main" id="{62012DB6-66C5-F173-10E9-B782EFD577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9713326"/>
            <a:ext cx="3726604" cy="10739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A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FNNILVGIIGNASLAEARLEKGSDALYLIKEIQDISEKAADLTKQMLAYTG---- KTKIDWKVSNLNVIIKEMNHLLNVSI-SKSIQLKYDMDDEIGLFEADVTQIRQIILNVVI 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SSEAIGEKNGVISIITRNQkidsnytvdfsfstdlkeGDYIYLEISDNGSGIPKHIINQ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IFDPFF----STKFTGRGLGLSVVQGIIKGHGGAIKVYSEMDKGTSFKFLFPRSE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70" name="Rectangle 25">
            <a:extLst>
              <a:ext uri="{FF2B5EF4-FFF2-40B4-BE49-F238E27FC236}">
                <a16:creationId xmlns:a16="http://schemas.microsoft.com/office/drawing/2014/main" id="{5D312870-7655-ECED-D357-73166D2E4C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10795659"/>
            <a:ext cx="3767557" cy="766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VLFCDDDPTITKTAENMLRYLGYEVIIASNGKEGIELLEENIdkIKLIIL</a:t>
            </a:r>
            <a:r>
              <a:rPr lang="es-MX" altLang="es-MX" sz="1000" b="1" dirty="0" err="1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TMPIMSG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KETFSKMRKISQNIPIILSSGYNEVEIVERFVGRNLTGFLQKPYSIDKLRQTINKAF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71" name="Rectangle 26">
            <a:extLst>
              <a:ext uri="{FF2B5EF4-FFF2-40B4-BE49-F238E27FC236}">
                <a16:creationId xmlns:a16="http://schemas.microsoft.com/office/drawing/2014/main" id="{83CA1945-D59A-D7B0-168F-66BA7D4007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11742688"/>
            <a:ext cx="3726604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LFELQGSQYAGDEVKVEKtyfesKNVPLFDANNQVIGLLGVAYDITPLKKIEVQLAE</a:t>
            </a:r>
            <a:r>
              <a:rPr lang="es-MX" altLang="es-MX" sz="100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72" name="Rectangle 27">
            <a:extLst>
              <a:ext uri="{FF2B5EF4-FFF2-40B4-BE49-F238E27FC236}">
                <a16:creationId xmlns:a16="http://schemas.microsoft.com/office/drawing/2014/main" id="{E5D4AE78-721E-AB19-3631-9846127BFC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1735108"/>
            <a:ext cx="3726604" cy="1227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A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FNNIMAVINGGIELI-KGNIYDDHSIKILEIIEKQTLKGGELVRQILDYSGNPFS ----FEKSVKIADFAIEMTQMLRLLLP---SEILLSLSAEDLSVKIDETQLQQVILNLVF NSKDALLDG-</a:t>
            </a: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EIDLSISRVsfgevrdfektyirrNNYVKLSVIDNGIGIEEELKKEIFN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PFVTSKPFGQ--GIGLGLSQVYGIVRQHRGYIYIDSTQGIGTETNIFLPEYT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73" name="Rectangle 28">
            <a:extLst>
              <a:ext uri="{FF2B5EF4-FFF2-40B4-BE49-F238E27FC236}">
                <a16:creationId xmlns:a16="http://schemas.microsoft.com/office/drawing/2014/main" id="{E34FCE8D-AAB4-D2E6-5A2A-31665CD888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3023442"/>
            <a:ext cx="3719535" cy="766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ILLVEDDDDVREITRTAMEYQGFDVVTATNGIEALQVYNDE-ISLIIT</a:t>
            </a:r>
            <a:r>
              <a:rPr lang="es-MX" altLang="es-MX" sz="1000" b="1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s-MX" altLang="es-MX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MPIMSGIE LINEIRSKDESAKIIAITGFPSMKVPKG------IQLLQKPVSNKELKEIIEESI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74" name="Rectangle 29">
            <a:extLst>
              <a:ext uri="{FF2B5EF4-FFF2-40B4-BE49-F238E27FC236}">
                <a16:creationId xmlns:a16="http://schemas.microsoft.com/office/drawing/2014/main" id="{7B3AEC39-29F9-B741-F61A-C7CC963627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1767" y="3975333"/>
            <a:ext cx="3619242" cy="458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74589" rIns="91440" bIns="74589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s-MX" altLang="es-MX" sz="1000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GNKYKYMFEYANDPIFLIRLESvgkfsKIVDVNTAACVKLGFSKEELL</a:t>
            </a:r>
            <a:r>
              <a:rPr lang="es-MX" altLang="es-MX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774730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393</TotalTime>
  <Words>558</Words>
  <Application>Microsoft Office PowerPoint</Application>
  <PresentationFormat>Personalizado</PresentationFormat>
  <Paragraphs>423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franco</dc:creator>
  <cp:lastModifiedBy>Bernardo Franco Bárcenas</cp:lastModifiedBy>
  <cp:revision>82</cp:revision>
  <dcterms:created xsi:type="dcterms:W3CDTF">2022-07-19T22:57:34Z</dcterms:created>
  <dcterms:modified xsi:type="dcterms:W3CDTF">2023-01-12T18:32:49Z</dcterms:modified>
</cp:coreProperties>
</file>